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278" r:id="rId5"/>
    <p:sldId id="259" r:id="rId6"/>
    <p:sldId id="313" r:id="rId7"/>
    <p:sldId id="285" r:id="rId8"/>
    <p:sldId id="282" r:id="rId9"/>
    <p:sldId id="283" r:id="rId10"/>
    <p:sldId id="280" r:id="rId11"/>
    <p:sldId id="281" r:id="rId12"/>
    <p:sldId id="284" r:id="rId13"/>
  </p:sldIdLst>
  <p:sldSz cx="9144000" cy="6858000" type="letter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8" d="100"/>
          <a:sy n="118" d="100"/>
        </p:scale>
        <p:origin x="1404" y="10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&#30424;\USDA-ARS\USDA-ARS\2019-&#31934;&#32454;&#23450;&#20301;\2019-4%20SNP&#33455;&#29255;&#25991;&#31456;&#25776;&#20889;\&#30011;&#22270;&#21644;&#34920;&#2668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5667928284326776E-2"/>
          <c:y val="4.3307086614173228E-2"/>
          <c:w val="0.92219036479135763"/>
          <c:h val="0.840357740715481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3!$K$1</c:f>
              <c:strCache>
                <c:ptCount val="1"/>
                <c:pt idx="0">
                  <c:v>A-subgenom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3!$J$2:$J$11</c:f>
              <c:strCache>
                <c:ptCount val="10"/>
                <c:pt idx="0">
                  <c:v>A01/B01</c:v>
                </c:pt>
                <c:pt idx="1">
                  <c:v>A02/B02</c:v>
                </c:pt>
                <c:pt idx="2">
                  <c:v>A03/B03</c:v>
                </c:pt>
                <c:pt idx="3">
                  <c:v>A04/B04</c:v>
                </c:pt>
                <c:pt idx="4">
                  <c:v>A05/B05</c:v>
                </c:pt>
                <c:pt idx="5">
                  <c:v>A06/B06</c:v>
                </c:pt>
                <c:pt idx="6">
                  <c:v>A07/B07</c:v>
                </c:pt>
                <c:pt idx="7">
                  <c:v>A08/B08</c:v>
                </c:pt>
                <c:pt idx="8">
                  <c:v>A09/B09</c:v>
                </c:pt>
                <c:pt idx="9">
                  <c:v>A10/B10</c:v>
                </c:pt>
              </c:strCache>
            </c:strRef>
          </c:cat>
          <c:val>
            <c:numRef>
              <c:f>Sheet3!$K$2:$K$11</c:f>
              <c:numCache>
                <c:formatCode>General</c:formatCode>
                <c:ptCount val="10"/>
                <c:pt idx="0">
                  <c:v>54</c:v>
                </c:pt>
                <c:pt idx="1">
                  <c:v>108</c:v>
                </c:pt>
                <c:pt idx="2">
                  <c:v>118</c:v>
                </c:pt>
                <c:pt idx="3">
                  <c:v>104</c:v>
                </c:pt>
                <c:pt idx="4">
                  <c:v>91</c:v>
                </c:pt>
                <c:pt idx="5">
                  <c:v>163</c:v>
                </c:pt>
                <c:pt idx="6">
                  <c:v>110</c:v>
                </c:pt>
                <c:pt idx="7">
                  <c:v>43</c:v>
                </c:pt>
                <c:pt idx="8">
                  <c:v>101</c:v>
                </c:pt>
                <c:pt idx="9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79-4DDA-AAEF-C511EE2C7B50}"/>
            </c:ext>
          </c:extLst>
        </c:ser>
        <c:ser>
          <c:idx val="1"/>
          <c:order val="1"/>
          <c:tx>
            <c:strRef>
              <c:f>Sheet3!$L$1</c:f>
              <c:strCache>
                <c:ptCount val="1"/>
                <c:pt idx="0">
                  <c:v>B-subgenom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3!$J$2:$J$11</c:f>
              <c:strCache>
                <c:ptCount val="10"/>
                <c:pt idx="0">
                  <c:v>A01/B01</c:v>
                </c:pt>
                <c:pt idx="1">
                  <c:v>A02/B02</c:v>
                </c:pt>
                <c:pt idx="2">
                  <c:v>A03/B03</c:v>
                </c:pt>
                <c:pt idx="3">
                  <c:v>A04/B04</c:v>
                </c:pt>
                <c:pt idx="4">
                  <c:v>A05/B05</c:v>
                </c:pt>
                <c:pt idx="5">
                  <c:v>A06/B06</c:v>
                </c:pt>
                <c:pt idx="6">
                  <c:v>A07/B07</c:v>
                </c:pt>
                <c:pt idx="7">
                  <c:v>A08/B08</c:v>
                </c:pt>
                <c:pt idx="8">
                  <c:v>A09/B09</c:v>
                </c:pt>
                <c:pt idx="9">
                  <c:v>A10/B10</c:v>
                </c:pt>
              </c:strCache>
            </c:strRef>
          </c:cat>
          <c:val>
            <c:numRef>
              <c:f>Sheet3!$L$2:$L$11</c:f>
              <c:numCache>
                <c:formatCode>General</c:formatCode>
                <c:ptCount val="10"/>
                <c:pt idx="0">
                  <c:v>93</c:v>
                </c:pt>
                <c:pt idx="1">
                  <c:v>82</c:v>
                </c:pt>
                <c:pt idx="2">
                  <c:v>103</c:v>
                </c:pt>
                <c:pt idx="3">
                  <c:v>111</c:v>
                </c:pt>
                <c:pt idx="4">
                  <c:v>60</c:v>
                </c:pt>
                <c:pt idx="5">
                  <c:v>88</c:v>
                </c:pt>
                <c:pt idx="6">
                  <c:v>80</c:v>
                </c:pt>
                <c:pt idx="7">
                  <c:v>81</c:v>
                </c:pt>
                <c:pt idx="8">
                  <c:v>77</c:v>
                </c:pt>
                <c:pt idx="9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C79-4DDA-AAEF-C511EE2C7B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5"/>
        <c:axId val="270215712"/>
        <c:axId val="270214928"/>
      </c:barChart>
      <c:catAx>
        <c:axId val="270215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70214928"/>
        <c:crosses val="autoZero"/>
        <c:auto val="1"/>
        <c:lblAlgn val="ctr"/>
        <c:lblOffset val="100"/>
        <c:noMultiLvlLbl val="0"/>
      </c:catAx>
      <c:valAx>
        <c:axId val="27021492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70215712"/>
        <c:crosses val="autoZero"/>
        <c:crossBetween val="between"/>
      </c:valAx>
      <c:spPr>
        <a:noFill/>
        <a:ln>
          <a:solidFill>
            <a:schemeClr val="bg1">
              <a:lumMod val="75000"/>
            </a:schemeClr>
          </a:solidFill>
        </a:ln>
        <a:effectLst/>
      </c:spPr>
    </c:plotArea>
    <c:legend>
      <c:legendPos val="b"/>
      <c:layout>
        <c:manualLayout>
          <c:xMode val="edge"/>
          <c:yMode val="edge"/>
          <c:x val="0.60461886618508676"/>
          <c:y val="9.7318184636369279E-2"/>
          <c:w val="0.34029124363582253"/>
          <c:h val="0.1866938715361321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6337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840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720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9187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3314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9177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0176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4218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0955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4166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5666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352E4-B67F-4149-984A-6797263FA6CD}" type="datetimeFigureOut">
              <a:rPr lang="zh-CN" altLang="en-US" smtClean="0"/>
              <a:t>2025/2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670395-F5A8-4F53-9EB5-562429035E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2196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111D96F-72AA-4558-986F-F2F14EC4101D}"/>
              </a:ext>
            </a:extLst>
          </p:cNvPr>
          <p:cNvSpPr txBox="1"/>
          <p:nvPr/>
        </p:nvSpPr>
        <p:spPr>
          <a:xfrm>
            <a:off x="2112248" y="5638189"/>
            <a:ext cx="61872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Figure S1. Integrated physical map of Tomato spotted wilt virus (TSWV) resistance QTLs on chromosome A01 from previous studies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Different colored bars represent QTLs identified in various studies, with each color corresponding to a distinct research effort. Flanking markers identified in these studies are positioned along the chromosome, helping to pinpoint overlapping or closely linked QTL regions associated with TSWV resistance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28EC150C-62F9-4CDE-A479-A2DE5620BBD2}"/>
              </a:ext>
            </a:extLst>
          </p:cNvPr>
          <p:cNvGrpSpPr/>
          <p:nvPr/>
        </p:nvGrpSpPr>
        <p:grpSpPr>
          <a:xfrm>
            <a:off x="755821" y="654271"/>
            <a:ext cx="1596088" cy="5268463"/>
            <a:chOff x="2860034" y="146832"/>
            <a:chExt cx="1915464" cy="6775438"/>
          </a:xfrm>
        </p:grpSpPr>
        <p:sp>
          <p:nvSpPr>
            <p:cNvPr id="5" name="圆角矩形 601">
              <a:extLst>
                <a:ext uri="{FF2B5EF4-FFF2-40B4-BE49-F238E27FC236}">
                  <a16:creationId xmlns:a16="http://schemas.microsoft.com/office/drawing/2014/main" id="{FA041D4C-B0C7-49D0-B4F8-FC248D4DDB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6652" y="776534"/>
              <a:ext cx="115442" cy="5815740"/>
            </a:xfrm>
            <a:prstGeom prst="roundRect">
              <a:avLst>
                <a:gd name="adj" fmla="val 50000"/>
              </a:avLst>
            </a:prstGeom>
            <a:solidFill>
              <a:srgbClr val="FFFFFF"/>
            </a:solidFill>
            <a:ln w="19050" algn="ctr">
              <a:solidFill>
                <a:srgbClr val="000000"/>
              </a:solidFill>
              <a:round/>
              <a:headEnd/>
              <a:tailEnd/>
            </a:ln>
          </p:spPr>
          <p:txBody>
            <a:bodyPr lIns="13716" tIns="0" rIns="0" bIns="0"/>
            <a:lstStyle/>
            <a:p>
              <a:endParaRPr lang="zh-CN" altLang="en-US" sz="600" b="1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0735454E-D668-4B59-A4EE-A1577EE13C6B}"/>
                </a:ext>
              </a:extLst>
            </p:cNvPr>
            <p:cNvSpPr txBox="1"/>
            <p:nvPr/>
          </p:nvSpPr>
          <p:spPr>
            <a:xfrm>
              <a:off x="2997499" y="146832"/>
              <a:ext cx="1777999" cy="356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omosome A01</a:t>
              </a:r>
            </a:p>
          </p:txBody>
        </p:sp>
        <p:cxnSp>
          <p:nvCxnSpPr>
            <p:cNvPr id="7" name="直接连接符 605">
              <a:extLst>
                <a:ext uri="{FF2B5EF4-FFF2-40B4-BE49-F238E27FC236}">
                  <a16:creationId xmlns:a16="http://schemas.microsoft.com/office/drawing/2014/main" id="{FC6FCA90-466A-4399-8DFC-69CA50BC661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51965" y="1327345"/>
              <a:ext cx="438678" cy="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8" name="直接连接符 605">
              <a:extLst>
                <a:ext uri="{FF2B5EF4-FFF2-40B4-BE49-F238E27FC236}">
                  <a16:creationId xmlns:a16="http://schemas.microsoft.com/office/drawing/2014/main" id="{BC15C750-E169-473A-BF12-4803F77FB180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78294" y="1873883"/>
              <a:ext cx="438678" cy="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9" name="直接连接符 605">
              <a:extLst>
                <a:ext uri="{FF2B5EF4-FFF2-40B4-BE49-F238E27FC236}">
                  <a16:creationId xmlns:a16="http://schemas.microsoft.com/office/drawing/2014/main" id="{7BDA4B32-FB87-4A3E-9319-B1F26C9903C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70487" y="2415165"/>
              <a:ext cx="438678" cy="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0" name="直接连接符 605">
              <a:extLst>
                <a:ext uri="{FF2B5EF4-FFF2-40B4-BE49-F238E27FC236}">
                  <a16:creationId xmlns:a16="http://schemas.microsoft.com/office/drawing/2014/main" id="{DAD95296-304D-4485-BB96-DE24A40A0DA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59353" y="2966959"/>
              <a:ext cx="438678" cy="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1" name="直接连接符 605">
              <a:extLst>
                <a:ext uri="{FF2B5EF4-FFF2-40B4-BE49-F238E27FC236}">
                  <a16:creationId xmlns:a16="http://schemas.microsoft.com/office/drawing/2014/main" id="{AACEC612-35F5-4D94-9F84-704EFAF02B3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51965" y="3497731"/>
              <a:ext cx="438678" cy="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2" name="直接连接符 605">
              <a:extLst>
                <a:ext uri="{FF2B5EF4-FFF2-40B4-BE49-F238E27FC236}">
                  <a16:creationId xmlns:a16="http://schemas.microsoft.com/office/drawing/2014/main" id="{26CD8E46-C121-41F1-9CA7-A23B7ABC3F8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59353" y="4060035"/>
              <a:ext cx="438678" cy="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3" name="直接连接符 605">
              <a:extLst>
                <a:ext uri="{FF2B5EF4-FFF2-40B4-BE49-F238E27FC236}">
                  <a16:creationId xmlns:a16="http://schemas.microsoft.com/office/drawing/2014/main" id="{C9BC148A-DA82-410E-86DC-4FF6C552A5A8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70487" y="4580296"/>
              <a:ext cx="438678" cy="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4" name="直接连接符 605">
              <a:extLst>
                <a:ext uri="{FF2B5EF4-FFF2-40B4-BE49-F238E27FC236}">
                  <a16:creationId xmlns:a16="http://schemas.microsoft.com/office/drawing/2014/main" id="{69C91B74-7EA7-4127-ACDE-BB6D83A12B3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70487" y="5111069"/>
              <a:ext cx="438678" cy="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5" name="直接连接符 605">
              <a:extLst>
                <a:ext uri="{FF2B5EF4-FFF2-40B4-BE49-F238E27FC236}">
                  <a16:creationId xmlns:a16="http://schemas.microsoft.com/office/drawing/2014/main" id="{6D021A68-DE64-416C-8D8B-B70FD9E8DF2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70487" y="5662862"/>
              <a:ext cx="438678" cy="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6" name="直接连接符 605">
              <a:extLst>
                <a:ext uri="{FF2B5EF4-FFF2-40B4-BE49-F238E27FC236}">
                  <a16:creationId xmlns:a16="http://schemas.microsoft.com/office/drawing/2014/main" id="{BDB2C3B0-9E35-45E4-B745-9F3EE1B99EC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59353" y="6214655"/>
              <a:ext cx="438678" cy="0"/>
            </a:xfrm>
            <a:prstGeom prst="line">
              <a:avLst/>
            </a:prstGeom>
            <a:noFill/>
            <a:ln w="9525" algn="ctr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17" name="Text Box 8">
              <a:extLst>
                <a:ext uri="{FF2B5EF4-FFF2-40B4-BE49-F238E27FC236}">
                  <a16:creationId xmlns:a16="http://schemas.microsoft.com/office/drawing/2014/main" id="{97B68AAA-3DF0-475A-A6E3-40FFC4D62C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56734" y="662625"/>
              <a:ext cx="660238" cy="338555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3C9BED6A-49F4-49AC-9BD4-03E328600C34}"/>
                </a:ext>
              </a:extLst>
            </p:cNvPr>
            <p:cNvSpPr txBox="1"/>
            <p:nvPr/>
          </p:nvSpPr>
          <p:spPr>
            <a:xfrm>
              <a:off x="2958886" y="1165989"/>
              <a:ext cx="660238" cy="326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9E0C31B4-C9D3-43FC-A8E0-E8907C8F8AE9}"/>
                </a:ext>
              </a:extLst>
            </p:cNvPr>
            <p:cNvSpPr txBox="1"/>
            <p:nvPr/>
          </p:nvSpPr>
          <p:spPr>
            <a:xfrm>
              <a:off x="2977000" y="1701280"/>
              <a:ext cx="660238" cy="326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1CD0D93C-EA69-4AA1-BBF7-119D78999799}"/>
                </a:ext>
              </a:extLst>
            </p:cNvPr>
            <p:cNvSpPr txBox="1"/>
            <p:nvPr/>
          </p:nvSpPr>
          <p:spPr>
            <a:xfrm>
              <a:off x="2966624" y="2264348"/>
              <a:ext cx="660238" cy="326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C15DE2A5-1F5D-4D0A-BB2B-6B641A53F580}"/>
                </a:ext>
              </a:extLst>
            </p:cNvPr>
            <p:cNvSpPr txBox="1"/>
            <p:nvPr/>
          </p:nvSpPr>
          <p:spPr>
            <a:xfrm>
              <a:off x="2937866" y="2785346"/>
              <a:ext cx="660238" cy="326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BF2C8CB7-74BC-4713-BBE0-0057B299006C}"/>
                </a:ext>
              </a:extLst>
            </p:cNvPr>
            <p:cNvSpPr txBox="1"/>
            <p:nvPr/>
          </p:nvSpPr>
          <p:spPr>
            <a:xfrm>
              <a:off x="2933266" y="3316694"/>
              <a:ext cx="660238" cy="326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6F43B60-D909-4B67-B691-0A2B28DBAAE8}"/>
                </a:ext>
              </a:extLst>
            </p:cNvPr>
            <p:cNvSpPr txBox="1"/>
            <p:nvPr/>
          </p:nvSpPr>
          <p:spPr>
            <a:xfrm>
              <a:off x="2927357" y="3879733"/>
              <a:ext cx="660238" cy="326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C38A1877-255A-45BD-9CC5-D96137996C1E}"/>
                </a:ext>
              </a:extLst>
            </p:cNvPr>
            <p:cNvSpPr txBox="1"/>
            <p:nvPr/>
          </p:nvSpPr>
          <p:spPr>
            <a:xfrm>
              <a:off x="2899115" y="4396311"/>
              <a:ext cx="660238" cy="326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E132C670-4C73-4C74-8BCC-4CEA2511C002}"/>
                </a:ext>
              </a:extLst>
            </p:cNvPr>
            <p:cNvSpPr txBox="1"/>
            <p:nvPr/>
          </p:nvSpPr>
          <p:spPr>
            <a:xfrm>
              <a:off x="2884758" y="4906705"/>
              <a:ext cx="660238" cy="326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3613A185-EE6C-4972-8066-93550BC20599}"/>
                </a:ext>
              </a:extLst>
            </p:cNvPr>
            <p:cNvSpPr txBox="1"/>
            <p:nvPr/>
          </p:nvSpPr>
          <p:spPr>
            <a:xfrm>
              <a:off x="2891743" y="5516306"/>
              <a:ext cx="91519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0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76716197-3845-470F-A6C4-0F60396AF31B}"/>
                </a:ext>
              </a:extLst>
            </p:cNvPr>
            <p:cNvSpPr txBox="1"/>
            <p:nvPr/>
          </p:nvSpPr>
          <p:spPr>
            <a:xfrm>
              <a:off x="2860034" y="6071276"/>
              <a:ext cx="91519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2D63CA54-9531-4889-9AC2-385E5611BF72}"/>
                </a:ext>
              </a:extLst>
            </p:cNvPr>
            <p:cNvSpPr txBox="1"/>
            <p:nvPr/>
          </p:nvSpPr>
          <p:spPr>
            <a:xfrm>
              <a:off x="3394499" y="6583715"/>
              <a:ext cx="91519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7 Mb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CB39273A-5775-4BFD-A3AD-1BD826D1882C}"/>
              </a:ext>
            </a:extLst>
          </p:cNvPr>
          <p:cNvCxnSpPr>
            <a:cxnSpLocks/>
          </p:cNvCxnSpPr>
          <p:nvPr/>
        </p:nvCxnSpPr>
        <p:spPr>
          <a:xfrm flipH="1">
            <a:off x="1676541" y="2198642"/>
            <a:ext cx="21788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5F47CEF9-41B4-48CD-9FD9-D9136AF19BC3}"/>
              </a:ext>
            </a:extLst>
          </p:cNvPr>
          <p:cNvSpPr txBox="1"/>
          <p:nvPr/>
        </p:nvSpPr>
        <p:spPr>
          <a:xfrm>
            <a:off x="1847725" y="2010260"/>
            <a:ext cx="116006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B555 (ARS721)</a:t>
            </a:r>
          </a:p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2121313-22130912)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8C65C568-AE92-4FAA-8E09-290294E48F1E}"/>
              </a:ext>
            </a:extLst>
          </p:cNvPr>
          <p:cNvCxnSpPr>
            <a:cxnSpLocks/>
          </p:cNvCxnSpPr>
          <p:nvPr/>
        </p:nvCxnSpPr>
        <p:spPr>
          <a:xfrm flipH="1">
            <a:off x="1685993" y="2618252"/>
            <a:ext cx="21788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AFCB104E-3B80-42E6-A849-AC00D6D71FEB}"/>
              </a:ext>
            </a:extLst>
          </p:cNvPr>
          <p:cNvSpPr txBox="1"/>
          <p:nvPr/>
        </p:nvSpPr>
        <p:spPr>
          <a:xfrm>
            <a:off x="1846800" y="2445129"/>
            <a:ext cx="1636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B831 (31452009-31451432)</a:t>
            </a:r>
          </a:p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B842 (33746295-33746817)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6EAB0FD2-2F0B-495A-B563-053F12221743}"/>
              </a:ext>
            </a:extLst>
          </p:cNvPr>
          <p:cNvCxnSpPr>
            <a:cxnSpLocks/>
          </p:cNvCxnSpPr>
          <p:nvPr/>
        </p:nvCxnSpPr>
        <p:spPr>
          <a:xfrm flipH="1">
            <a:off x="1685159" y="3129266"/>
            <a:ext cx="21788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矩形 33">
            <a:extLst>
              <a:ext uri="{FF2B5EF4-FFF2-40B4-BE49-F238E27FC236}">
                <a16:creationId xmlns:a16="http://schemas.microsoft.com/office/drawing/2014/main" id="{0911F457-938D-4829-B733-9427392F84AB}"/>
              </a:ext>
            </a:extLst>
          </p:cNvPr>
          <p:cNvSpPr/>
          <p:nvPr/>
        </p:nvSpPr>
        <p:spPr>
          <a:xfrm>
            <a:off x="6461596" y="1400827"/>
            <a:ext cx="1394573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TSWV2,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E 35.8%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05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Qin et al 2012)</a:t>
            </a:r>
          </a:p>
        </p:txBody>
      </p:sp>
      <p:sp>
        <p:nvSpPr>
          <p:cNvPr id="35" name="矩形: 圆角 34">
            <a:extLst>
              <a:ext uri="{FF2B5EF4-FFF2-40B4-BE49-F238E27FC236}">
                <a16:creationId xmlns:a16="http://schemas.microsoft.com/office/drawing/2014/main" id="{83884337-1EEF-4CA7-BA22-F4FEAA71A4A2}"/>
              </a:ext>
            </a:extLst>
          </p:cNvPr>
          <p:cNvSpPr/>
          <p:nvPr/>
        </p:nvSpPr>
        <p:spPr>
          <a:xfrm>
            <a:off x="3701459" y="1986065"/>
            <a:ext cx="178032" cy="324697"/>
          </a:xfrm>
          <a:prstGeom prst="round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>
              <a:solidFill>
                <a:srgbClr val="0000FF"/>
              </a:solidFill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0231835A-5418-48CC-9CC6-CCBA23A3B023}"/>
              </a:ext>
            </a:extLst>
          </p:cNvPr>
          <p:cNvSpPr/>
          <p:nvPr/>
        </p:nvSpPr>
        <p:spPr>
          <a:xfrm>
            <a:off x="6437721" y="1809493"/>
            <a:ext cx="2004395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TSW_T13_A01_4,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E 29.14%</a:t>
            </a:r>
          </a:p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hera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16)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2011AE9F-327D-4E11-9A5F-74DCA4857F44}"/>
              </a:ext>
            </a:extLst>
          </p:cNvPr>
          <p:cNvCxnSpPr>
            <a:cxnSpLocks/>
          </p:cNvCxnSpPr>
          <p:nvPr/>
        </p:nvCxnSpPr>
        <p:spPr>
          <a:xfrm flipH="1">
            <a:off x="1688150" y="3664110"/>
            <a:ext cx="21788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矩形: 圆角 37">
            <a:extLst>
              <a:ext uri="{FF2B5EF4-FFF2-40B4-BE49-F238E27FC236}">
                <a16:creationId xmlns:a16="http://schemas.microsoft.com/office/drawing/2014/main" id="{0713D869-BEB3-4B83-997E-36A9DD1CF894}"/>
              </a:ext>
            </a:extLst>
          </p:cNvPr>
          <p:cNvSpPr/>
          <p:nvPr/>
        </p:nvSpPr>
        <p:spPr>
          <a:xfrm>
            <a:off x="3486018" y="1900304"/>
            <a:ext cx="158302" cy="919734"/>
          </a:xfrm>
          <a:prstGeom prst="round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>
              <a:solidFill>
                <a:srgbClr val="0000FF"/>
              </a:solidFill>
            </a:endParaRPr>
          </a:p>
        </p:txBody>
      </p:sp>
      <p:sp>
        <p:nvSpPr>
          <p:cNvPr id="39" name="矩形: 圆角 38">
            <a:extLst>
              <a:ext uri="{FF2B5EF4-FFF2-40B4-BE49-F238E27FC236}">
                <a16:creationId xmlns:a16="http://schemas.microsoft.com/office/drawing/2014/main" id="{A6204EBA-277E-488A-9D7D-62BC858CE6F4}"/>
              </a:ext>
            </a:extLst>
          </p:cNvPr>
          <p:cNvSpPr/>
          <p:nvPr/>
        </p:nvSpPr>
        <p:spPr>
          <a:xfrm>
            <a:off x="6366182" y="1435445"/>
            <a:ext cx="114462" cy="324697"/>
          </a:xfrm>
          <a:prstGeom prst="round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>
              <a:solidFill>
                <a:srgbClr val="0000FF"/>
              </a:solidFill>
            </a:endParaRPr>
          </a:p>
        </p:txBody>
      </p:sp>
      <p:sp>
        <p:nvSpPr>
          <p:cNvPr id="40" name="矩形: 圆角 39">
            <a:extLst>
              <a:ext uri="{FF2B5EF4-FFF2-40B4-BE49-F238E27FC236}">
                <a16:creationId xmlns:a16="http://schemas.microsoft.com/office/drawing/2014/main" id="{05C00F73-1C51-4F27-B8CD-7501F2E74141}"/>
              </a:ext>
            </a:extLst>
          </p:cNvPr>
          <p:cNvSpPr/>
          <p:nvPr/>
        </p:nvSpPr>
        <p:spPr>
          <a:xfrm>
            <a:off x="6367816" y="1849022"/>
            <a:ext cx="114461" cy="333121"/>
          </a:xfrm>
          <a:prstGeom prst="round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>
              <a:solidFill>
                <a:srgbClr val="0000FF"/>
              </a:solidFill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345BCE7A-99DF-4ACD-A670-4F21DE52F22A}"/>
              </a:ext>
            </a:extLst>
          </p:cNvPr>
          <p:cNvSpPr/>
          <p:nvPr/>
        </p:nvSpPr>
        <p:spPr>
          <a:xfrm>
            <a:off x="1857193" y="3491611"/>
            <a:ext cx="1298330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HGS4584 (57792090)</a:t>
            </a:r>
            <a:r>
              <a:rPr lang="en-US" altLang="zh-CN" sz="1350" dirty="0"/>
              <a:t> </a:t>
            </a:r>
            <a:endParaRPr lang="zh-CN" altLang="en-US" sz="1350" dirty="0"/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44210096-3B19-40C6-84F4-375B0432B9AE}"/>
              </a:ext>
            </a:extLst>
          </p:cNvPr>
          <p:cNvCxnSpPr>
            <a:cxnSpLocks/>
          </p:cNvCxnSpPr>
          <p:nvPr/>
        </p:nvCxnSpPr>
        <p:spPr>
          <a:xfrm flipH="1">
            <a:off x="1703204" y="4259093"/>
            <a:ext cx="21788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矩形: 圆角 42">
            <a:extLst>
              <a:ext uri="{FF2B5EF4-FFF2-40B4-BE49-F238E27FC236}">
                <a16:creationId xmlns:a16="http://schemas.microsoft.com/office/drawing/2014/main" id="{C5190740-AE5F-4A11-803D-FBC5AEAB583D}"/>
              </a:ext>
            </a:extLst>
          </p:cNvPr>
          <p:cNvSpPr/>
          <p:nvPr/>
        </p:nvSpPr>
        <p:spPr>
          <a:xfrm>
            <a:off x="3085085" y="3569979"/>
            <a:ext cx="161500" cy="745169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>
              <a:solidFill>
                <a:srgbClr val="0000FF"/>
              </a:solidFill>
            </a:endParaRP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6C9B284D-CEE3-4379-8A0F-C596D863FD76}"/>
              </a:ext>
            </a:extLst>
          </p:cNvPr>
          <p:cNvSpPr/>
          <p:nvPr/>
        </p:nvSpPr>
        <p:spPr>
          <a:xfrm>
            <a:off x="6438567" y="2212915"/>
            <a:ext cx="2004395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TL for TSWV, PVE 22.7%</a:t>
            </a:r>
          </a:p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seng et al., 2016)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: 圆角 44">
            <a:extLst>
              <a:ext uri="{FF2B5EF4-FFF2-40B4-BE49-F238E27FC236}">
                <a16:creationId xmlns:a16="http://schemas.microsoft.com/office/drawing/2014/main" id="{56A134CD-FA49-4AA0-9033-31F417B87744}"/>
              </a:ext>
            </a:extLst>
          </p:cNvPr>
          <p:cNvSpPr/>
          <p:nvPr/>
        </p:nvSpPr>
        <p:spPr>
          <a:xfrm>
            <a:off x="6368663" y="2252443"/>
            <a:ext cx="114461" cy="333121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>
              <a:solidFill>
                <a:schemeClr val="tx1"/>
              </a:solidFill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AAB74E99-357E-465E-AC73-1458E63DFEA0}"/>
              </a:ext>
            </a:extLst>
          </p:cNvPr>
          <p:cNvSpPr/>
          <p:nvPr/>
        </p:nvSpPr>
        <p:spPr>
          <a:xfrm>
            <a:off x="1849072" y="2910576"/>
            <a:ext cx="13260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HGS3363 (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634304</a:t>
            </a:r>
            <a:r>
              <a: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</a:p>
          <a:p>
            <a:r>
              <a:rPr lang="en-US" altLang="zh-CN" sz="9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HGS1646 (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349687</a:t>
            </a:r>
            <a:r>
              <a: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079D138F-32F1-4F40-9AE9-4B55EC36DE22}"/>
              </a:ext>
            </a:extLst>
          </p:cNvPr>
          <p:cNvCxnSpPr>
            <a:cxnSpLocks/>
          </p:cNvCxnSpPr>
          <p:nvPr/>
        </p:nvCxnSpPr>
        <p:spPr>
          <a:xfrm flipH="1">
            <a:off x="1685159" y="3063247"/>
            <a:ext cx="21788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矩形: 圆角 47">
            <a:extLst>
              <a:ext uri="{FF2B5EF4-FFF2-40B4-BE49-F238E27FC236}">
                <a16:creationId xmlns:a16="http://schemas.microsoft.com/office/drawing/2014/main" id="{951B5C24-ED81-4AC3-8BC5-767B58D9E066}"/>
              </a:ext>
            </a:extLst>
          </p:cNvPr>
          <p:cNvSpPr/>
          <p:nvPr/>
        </p:nvSpPr>
        <p:spPr>
          <a:xfrm>
            <a:off x="3104592" y="2993562"/>
            <a:ext cx="142308" cy="223493"/>
          </a:xfrm>
          <a:prstGeom prst="roundRect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>
              <a:solidFill>
                <a:srgbClr val="0000FF"/>
              </a:solidFill>
            </a:endParaRPr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DBB63B96-E92E-4B1F-B365-254525213E49}"/>
              </a:ext>
            </a:extLst>
          </p:cNvPr>
          <p:cNvSpPr/>
          <p:nvPr/>
        </p:nvSpPr>
        <p:spPr>
          <a:xfrm>
            <a:off x="6437721" y="2662597"/>
            <a:ext cx="2004395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TL for TSWV, PVE 22.8%</a:t>
            </a:r>
          </a:p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Zhao et al., 2018)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矩形: 圆角 49">
            <a:extLst>
              <a:ext uri="{FF2B5EF4-FFF2-40B4-BE49-F238E27FC236}">
                <a16:creationId xmlns:a16="http://schemas.microsoft.com/office/drawing/2014/main" id="{29BD8979-FB98-41FA-965E-11DFE4C26CD8}"/>
              </a:ext>
            </a:extLst>
          </p:cNvPr>
          <p:cNvSpPr/>
          <p:nvPr/>
        </p:nvSpPr>
        <p:spPr>
          <a:xfrm>
            <a:off x="6367816" y="2702126"/>
            <a:ext cx="114461" cy="333121"/>
          </a:xfrm>
          <a:prstGeom prst="roundRect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>
              <a:solidFill>
                <a:schemeClr val="tx1"/>
              </a:solidFill>
            </a:endParaRPr>
          </a:p>
        </p:txBody>
      </p: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5C568A0D-4F85-4B8D-AE89-8EECAC486A62}"/>
              </a:ext>
            </a:extLst>
          </p:cNvPr>
          <p:cNvCxnSpPr>
            <a:cxnSpLocks/>
          </p:cNvCxnSpPr>
          <p:nvPr/>
        </p:nvCxnSpPr>
        <p:spPr>
          <a:xfrm flipH="1">
            <a:off x="1682319" y="1685565"/>
            <a:ext cx="21788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7CD52719-4479-4D79-984C-DE15C275A15D}"/>
              </a:ext>
            </a:extLst>
          </p:cNvPr>
          <p:cNvSpPr txBox="1"/>
          <p:nvPr/>
        </p:nvSpPr>
        <p:spPr>
          <a:xfrm>
            <a:off x="1883026" y="1568553"/>
            <a:ext cx="1586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 (9457148-9546698)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矩形: 圆角 52">
            <a:extLst>
              <a:ext uri="{FF2B5EF4-FFF2-40B4-BE49-F238E27FC236}">
                <a16:creationId xmlns:a16="http://schemas.microsoft.com/office/drawing/2014/main" id="{59DE177E-4AA9-417D-B7E6-1176427F0EB4}"/>
              </a:ext>
            </a:extLst>
          </p:cNvPr>
          <p:cNvSpPr/>
          <p:nvPr/>
        </p:nvSpPr>
        <p:spPr>
          <a:xfrm>
            <a:off x="3056150" y="1582140"/>
            <a:ext cx="142308" cy="223493"/>
          </a:xfrm>
          <a:prstGeom prst="round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>
              <a:solidFill>
                <a:srgbClr val="0000FF"/>
              </a:solidFill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3834F0E6-FBBB-4B28-A041-8B505B97AF1E}"/>
              </a:ext>
            </a:extLst>
          </p:cNvPr>
          <p:cNvSpPr/>
          <p:nvPr/>
        </p:nvSpPr>
        <p:spPr>
          <a:xfrm>
            <a:off x="6439624" y="3159807"/>
            <a:ext cx="2774754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TL for TSWV, PVE 36.5%</a:t>
            </a:r>
          </a:p>
          <a:p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 Agarwal et al</a:t>
            </a:r>
            <a:r>
              <a:rPr lang="en-US" altLang="zh-CN" sz="1050">
                <a:latin typeface="Times New Roman" panose="02020603050405020304" pitchFamily="18" charset="0"/>
                <a:cs typeface="Times New Roman" panose="02020603050405020304" pitchFamily="18" charset="0"/>
              </a:rPr>
              <a:t>., 2019)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矩形: 圆角 54">
            <a:extLst>
              <a:ext uri="{FF2B5EF4-FFF2-40B4-BE49-F238E27FC236}">
                <a16:creationId xmlns:a16="http://schemas.microsoft.com/office/drawing/2014/main" id="{6457C5BE-6301-45F7-98AF-2279ED5B4FD5}"/>
              </a:ext>
            </a:extLst>
          </p:cNvPr>
          <p:cNvSpPr/>
          <p:nvPr/>
        </p:nvSpPr>
        <p:spPr>
          <a:xfrm>
            <a:off x="6369721" y="3199335"/>
            <a:ext cx="114461" cy="333121"/>
          </a:xfrm>
          <a:prstGeom prst="round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>
              <a:solidFill>
                <a:schemeClr val="tx1"/>
              </a:solidFill>
            </a:endParaRPr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78C91A29-E9AC-4006-9217-67E605852F2E}"/>
              </a:ext>
            </a:extLst>
          </p:cNvPr>
          <p:cNvSpPr/>
          <p:nvPr/>
        </p:nvSpPr>
        <p:spPr>
          <a:xfrm>
            <a:off x="3840096" y="2018716"/>
            <a:ext cx="850692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E 35.8%</a:t>
            </a:r>
            <a:endParaRPr lang="zh-CN" altLang="en-US" sz="105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28749E08-18FD-45B0-A74F-1205560F769E}"/>
              </a:ext>
            </a:extLst>
          </p:cNvPr>
          <p:cNvSpPr/>
          <p:nvPr/>
        </p:nvSpPr>
        <p:spPr>
          <a:xfrm>
            <a:off x="3204999" y="1598234"/>
            <a:ext cx="919057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E 36.5%</a:t>
            </a:r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33836452-9166-4D15-A76D-AF4446EB1DA5}"/>
              </a:ext>
            </a:extLst>
          </p:cNvPr>
          <p:cNvSpPr/>
          <p:nvPr/>
        </p:nvSpPr>
        <p:spPr>
          <a:xfrm>
            <a:off x="3604496" y="2442750"/>
            <a:ext cx="919057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E 29.14%</a:t>
            </a: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2F286696-1998-4AE4-913A-D80C0BC3693C}"/>
              </a:ext>
            </a:extLst>
          </p:cNvPr>
          <p:cNvSpPr/>
          <p:nvPr/>
        </p:nvSpPr>
        <p:spPr>
          <a:xfrm>
            <a:off x="3204999" y="3000561"/>
            <a:ext cx="919057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VE 22.8%</a:t>
            </a: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36DE22E6-16AD-47F7-A1EE-4C9968783708}"/>
              </a:ext>
            </a:extLst>
          </p:cNvPr>
          <p:cNvSpPr/>
          <p:nvPr/>
        </p:nvSpPr>
        <p:spPr>
          <a:xfrm>
            <a:off x="1875281" y="4102220"/>
            <a:ext cx="1298330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672 (72196023)</a:t>
            </a:r>
            <a:r>
              <a:rPr lang="en-US" altLang="zh-CN" sz="1350" dirty="0"/>
              <a:t> </a:t>
            </a:r>
            <a:endParaRPr lang="zh-CN" altLang="en-US" sz="1350" dirty="0"/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3CF958C0-2D63-4294-9F44-9AC1D8E382DB}"/>
              </a:ext>
            </a:extLst>
          </p:cNvPr>
          <p:cNvSpPr/>
          <p:nvPr/>
        </p:nvSpPr>
        <p:spPr>
          <a:xfrm>
            <a:off x="3241934" y="3876116"/>
            <a:ext cx="919057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VE 22.7%</a:t>
            </a:r>
          </a:p>
        </p:txBody>
      </p:sp>
      <p:sp>
        <p:nvSpPr>
          <p:cNvPr id="62" name="等腰三角形 61">
            <a:extLst>
              <a:ext uri="{FF2B5EF4-FFF2-40B4-BE49-F238E27FC236}">
                <a16:creationId xmlns:a16="http://schemas.microsoft.com/office/drawing/2014/main" id="{5941FE34-F67B-47DB-B5D9-8A757FD053C3}"/>
              </a:ext>
            </a:extLst>
          </p:cNvPr>
          <p:cNvSpPr/>
          <p:nvPr/>
        </p:nvSpPr>
        <p:spPr>
          <a:xfrm rot="5400000">
            <a:off x="3312704" y="2072875"/>
            <a:ext cx="114461" cy="181493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/>
          </a:p>
        </p:txBody>
      </p:sp>
      <p:sp>
        <p:nvSpPr>
          <p:cNvPr id="63" name="等腰三角形 62">
            <a:extLst>
              <a:ext uri="{FF2B5EF4-FFF2-40B4-BE49-F238E27FC236}">
                <a16:creationId xmlns:a16="http://schemas.microsoft.com/office/drawing/2014/main" id="{9171B8F0-7308-4AA5-A3CA-7228F86444DD}"/>
              </a:ext>
            </a:extLst>
          </p:cNvPr>
          <p:cNvSpPr/>
          <p:nvPr/>
        </p:nvSpPr>
        <p:spPr>
          <a:xfrm rot="5400000">
            <a:off x="6427899" y="4263924"/>
            <a:ext cx="114461" cy="181493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zh-CN" altLang="en-US" sz="1350"/>
          </a:p>
        </p:txBody>
      </p:sp>
      <p:sp>
        <p:nvSpPr>
          <p:cNvPr id="64" name="矩形 63">
            <a:extLst>
              <a:ext uri="{FF2B5EF4-FFF2-40B4-BE49-F238E27FC236}">
                <a16:creationId xmlns:a16="http://schemas.microsoft.com/office/drawing/2014/main" id="{BDCF3789-37A7-4CB0-A66C-9429F37CF1A7}"/>
              </a:ext>
            </a:extLst>
          </p:cNvPr>
          <p:cNvSpPr/>
          <p:nvPr/>
        </p:nvSpPr>
        <p:spPr>
          <a:xfrm>
            <a:off x="6504178" y="4238142"/>
            <a:ext cx="2301783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earest marker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E8635FD2-1D6C-4F49-94CF-BAD4D239D7CC}"/>
              </a:ext>
            </a:extLst>
          </p:cNvPr>
          <p:cNvSpPr/>
          <p:nvPr/>
        </p:nvSpPr>
        <p:spPr>
          <a:xfrm>
            <a:off x="1877402" y="1452812"/>
            <a:ext cx="113364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(</a:t>
            </a:r>
            <a:r>
              <a: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01_9205209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直接箭头连接符 66">
            <a:extLst>
              <a:ext uri="{FF2B5EF4-FFF2-40B4-BE49-F238E27FC236}">
                <a16:creationId xmlns:a16="http://schemas.microsoft.com/office/drawing/2014/main" id="{A2203594-9D4F-41BC-B72A-746C21D790BC}"/>
              </a:ext>
            </a:extLst>
          </p:cNvPr>
          <p:cNvCxnSpPr>
            <a:cxnSpLocks/>
          </p:cNvCxnSpPr>
          <p:nvPr/>
        </p:nvCxnSpPr>
        <p:spPr>
          <a:xfrm flipH="1">
            <a:off x="1697490" y="1556687"/>
            <a:ext cx="21788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右大括号 71">
            <a:extLst>
              <a:ext uri="{FF2B5EF4-FFF2-40B4-BE49-F238E27FC236}">
                <a16:creationId xmlns:a16="http://schemas.microsoft.com/office/drawing/2014/main" id="{C1B04539-671B-45BB-A48F-0236BCB6F450}"/>
              </a:ext>
            </a:extLst>
          </p:cNvPr>
          <p:cNvSpPr/>
          <p:nvPr/>
        </p:nvSpPr>
        <p:spPr>
          <a:xfrm>
            <a:off x="4592493" y="1398151"/>
            <a:ext cx="150988" cy="1512424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sp>
        <p:nvSpPr>
          <p:cNvPr id="73" name="右大括号 72">
            <a:extLst>
              <a:ext uri="{FF2B5EF4-FFF2-40B4-BE49-F238E27FC236}">
                <a16:creationId xmlns:a16="http://schemas.microsoft.com/office/drawing/2014/main" id="{5CC968D4-828F-49C0-9F31-93709C935C51}"/>
              </a:ext>
            </a:extLst>
          </p:cNvPr>
          <p:cNvSpPr/>
          <p:nvPr/>
        </p:nvSpPr>
        <p:spPr>
          <a:xfrm>
            <a:off x="4604744" y="3035247"/>
            <a:ext cx="114462" cy="134397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1350"/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2001E14E-74DA-4B2A-8FBF-056A37E36C1D}"/>
              </a:ext>
            </a:extLst>
          </p:cNvPr>
          <p:cNvSpPr/>
          <p:nvPr/>
        </p:nvSpPr>
        <p:spPr>
          <a:xfrm>
            <a:off x="4834451" y="2147762"/>
            <a:ext cx="1079142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350" dirty="0">
                <a:latin typeface="Times New Roman" panose="02020603050405020304" pitchFamily="18" charset="0"/>
                <a:ea typeface="宋体" panose="02010600030101010101" pitchFamily="2" charset="-122"/>
              </a:rPr>
              <a:t>S-population</a:t>
            </a:r>
            <a:endParaRPr lang="zh-CN" altLang="en-US" sz="1350" dirty="0"/>
          </a:p>
        </p:txBody>
      </p:sp>
      <p:sp>
        <p:nvSpPr>
          <p:cNvPr id="75" name="矩形 74">
            <a:extLst>
              <a:ext uri="{FF2B5EF4-FFF2-40B4-BE49-F238E27FC236}">
                <a16:creationId xmlns:a16="http://schemas.microsoft.com/office/drawing/2014/main" id="{05A1F94E-173B-4BB1-AEEA-0576DB1C17C1}"/>
              </a:ext>
            </a:extLst>
          </p:cNvPr>
          <p:cNvSpPr/>
          <p:nvPr/>
        </p:nvSpPr>
        <p:spPr>
          <a:xfrm>
            <a:off x="4834451" y="3778201"/>
            <a:ext cx="1184940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350" dirty="0">
                <a:latin typeface="Times New Roman" panose="02020603050405020304" pitchFamily="18" charset="0"/>
                <a:ea typeface="宋体" panose="02010600030101010101" pitchFamily="2" charset="-122"/>
              </a:rPr>
              <a:t>FL-population</a:t>
            </a:r>
            <a:endParaRPr lang="zh-CN" altLang="en-US" sz="1350" dirty="0"/>
          </a:p>
        </p:txBody>
      </p:sp>
    </p:spTree>
    <p:extLst>
      <p:ext uri="{BB962C8B-B14F-4D97-AF65-F5344CB8AC3E}">
        <p14:creationId xmlns:p14="http://schemas.microsoft.com/office/powerpoint/2010/main" val="4014553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6CEB2312-F1C5-4BC1-92AB-4762C955E6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9862886"/>
              </p:ext>
            </p:extLst>
          </p:nvPr>
        </p:nvGraphicFramePr>
        <p:xfrm>
          <a:off x="4079155" y="1859622"/>
          <a:ext cx="4408268" cy="21986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C914E04C-3AB0-4239-8C48-231F923AE471}"/>
              </a:ext>
            </a:extLst>
          </p:cNvPr>
          <p:cNvSpPr txBox="1"/>
          <p:nvPr/>
        </p:nvSpPr>
        <p:spPr>
          <a:xfrm rot="16200000">
            <a:off x="3335768" y="2653008"/>
            <a:ext cx="12559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SNPs</a:t>
            </a:r>
            <a:endParaRPr lang="zh-CN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CF4974A-DB6C-44D3-804B-1A683D557A75}"/>
              </a:ext>
            </a:extLst>
          </p:cNvPr>
          <p:cNvSpPr txBox="1"/>
          <p:nvPr/>
        </p:nvSpPr>
        <p:spPr>
          <a:xfrm>
            <a:off x="5666919" y="3951063"/>
            <a:ext cx="128497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</a:t>
            </a:r>
            <a:endParaRPr lang="zh-CN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60D71D0C-CA31-46FC-A048-26FBFC352640}"/>
              </a:ext>
            </a:extLst>
          </p:cNvPr>
          <p:cNvSpPr/>
          <p:nvPr/>
        </p:nvSpPr>
        <p:spPr>
          <a:xfrm>
            <a:off x="583522" y="4487829"/>
            <a:ext cx="797695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algn="just">
              <a:spcBef>
                <a:spcPts val="600"/>
              </a:spcBef>
              <a:spcAft>
                <a:spcPts val="10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. Identification polymorphic SNP markers between parents using version 1 peanut SNP array.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a): Number of different type of SNPs in parents. (b): Distribution of polymorphic SNPs in chromosomes of peanut.</a:t>
            </a:r>
            <a:endParaRPr lang="en-US" sz="1200" dirty="0">
              <a:effectLst/>
              <a:latin typeface="Times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id="{29EFBB7F-C6D3-45D5-B963-C850154E05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280312"/>
              </p:ext>
            </p:extLst>
          </p:nvPr>
        </p:nvGraphicFramePr>
        <p:xfrm>
          <a:off x="754298" y="2031045"/>
          <a:ext cx="2400299" cy="18516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2939">
                  <a:extLst>
                    <a:ext uri="{9D8B030D-6E8A-4147-A177-3AD203B41FA5}">
                      <a16:colId xmlns:a16="http://schemas.microsoft.com/office/drawing/2014/main" val="2805520821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3348087620"/>
                    </a:ext>
                  </a:extLst>
                </a:gridCol>
                <a:gridCol w="601980">
                  <a:extLst>
                    <a:ext uri="{9D8B030D-6E8A-4147-A177-3AD203B41FA5}">
                      <a16:colId xmlns:a16="http://schemas.microsoft.com/office/drawing/2014/main" val="3948986685"/>
                    </a:ext>
                  </a:extLst>
                </a:gridCol>
                <a:gridCol w="541020">
                  <a:extLst>
                    <a:ext uri="{9D8B030D-6E8A-4147-A177-3AD203B41FA5}">
                      <a16:colId xmlns:a16="http://schemas.microsoft.com/office/drawing/2014/main" val="2822455998"/>
                    </a:ext>
                  </a:extLst>
                </a:gridCol>
              </a:tblGrid>
              <a:tr h="46291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otype</a:t>
                      </a:r>
                      <a:endParaRPr lang="zh-CN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6458218"/>
                  </a:ext>
                </a:extLst>
              </a:tr>
              <a:tr h="4629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6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4240191"/>
                  </a:ext>
                </a:extLst>
              </a:tr>
              <a:tr h="4629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8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8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4603641"/>
                  </a:ext>
                </a:extLst>
              </a:tr>
              <a:tr h="4629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6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9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763" marR="4763" marT="4763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2382362"/>
                  </a:ext>
                </a:extLst>
              </a:tr>
            </a:tbl>
          </a:graphicData>
        </a:graphic>
      </p:graphicFrame>
      <p:sp>
        <p:nvSpPr>
          <p:cNvPr id="9" name="矩形 8">
            <a:extLst>
              <a:ext uri="{FF2B5EF4-FFF2-40B4-BE49-F238E27FC236}">
                <a16:creationId xmlns:a16="http://schemas.microsoft.com/office/drawing/2014/main" id="{8EB0C747-604C-4ABE-B3B4-19A6B69DF4C8}"/>
              </a:ext>
            </a:extLst>
          </p:cNvPr>
          <p:cNvSpPr/>
          <p:nvPr/>
        </p:nvSpPr>
        <p:spPr>
          <a:xfrm>
            <a:off x="1282871" y="1731233"/>
            <a:ext cx="13821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Oleic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7R (</a:t>
            </a:r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♀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A9EDCA69-7A76-4F87-999D-8C1EE8CD42B5}"/>
              </a:ext>
            </a:extLst>
          </p:cNvPr>
          <p:cNvSpPr/>
          <p:nvPr/>
        </p:nvSpPr>
        <p:spPr>
          <a:xfrm rot="16200000">
            <a:off x="73022" y="2818376"/>
            <a:ext cx="1085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94022 (</a:t>
            </a:r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♂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C0CC067-E3AE-4D2F-87BB-D96011CF7430}"/>
              </a:ext>
            </a:extLst>
          </p:cNvPr>
          <p:cNvSpPr txBox="1"/>
          <p:nvPr/>
        </p:nvSpPr>
        <p:spPr>
          <a:xfrm>
            <a:off x="55725" y="1595981"/>
            <a:ext cx="5099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CE054B0-7B9F-403A-9681-1C6B1183067A}"/>
              </a:ext>
            </a:extLst>
          </p:cNvPr>
          <p:cNvSpPr txBox="1"/>
          <p:nvPr/>
        </p:nvSpPr>
        <p:spPr>
          <a:xfrm>
            <a:off x="3569187" y="1546567"/>
            <a:ext cx="5099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94029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2">
            <a:extLst>
              <a:ext uri="{FF2B5EF4-FFF2-40B4-BE49-F238E27FC236}">
                <a16:creationId xmlns:a16="http://schemas.microsoft.com/office/drawing/2014/main" id="{CCFE5C96-5A4C-7B22-2414-FA39D3E95A50}"/>
              </a:ext>
            </a:extLst>
          </p:cNvPr>
          <p:cNvSpPr/>
          <p:nvPr/>
        </p:nvSpPr>
        <p:spPr>
          <a:xfrm>
            <a:off x="651301" y="5303081"/>
            <a:ext cx="801111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algn="just">
              <a:spcBef>
                <a:spcPts val="600"/>
              </a:spcBef>
            </a:pPr>
            <a:r>
              <a:rPr lang="en-US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3.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Genotypic variation across SNP positions on chromosome A01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ased on the physic genome sequences of the parental lines (NC94022 and SunOleic97R) and these two rare recombinant inbred lines (RIL-S1 and RIL-S17) in the cold spot. 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lue cells: Alleles inherited from the resistant parent (NC94022). Orange cells: Alleles inherited from the susceptible parent (SunOleic97R). A recombination event near 11.9 Mb–12.06 Mb highlights a crossover in the QTL region, supporting the recombination cold spot.</a:t>
            </a:r>
            <a:endParaRPr lang="en-US" sz="12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buFont typeface="Arial" panose="020B0604020202020204" pitchFamily="34" charset="0"/>
              <a:buChar char="•"/>
            </a:pP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screenshot of a computer&#10;&#10;Description automatically generated">
            <a:extLst>
              <a:ext uri="{FF2B5EF4-FFF2-40B4-BE49-F238E27FC236}">
                <a16:creationId xmlns:a16="http://schemas.microsoft.com/office/drawing/2014/main" id="{EFE40FEB-14BB-3FA9-E01D-6F5B581E5B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56" b="10657"/>
          <a:stretch/>
        </p:blipFill>
        <p:spPr>
          <a:xfrm>
            <a:off x="2284268" y="163283"/>
            <a:ext cx="4745182" cy="5010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87268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5560620-B34B-4703-F642-B0F6ED6E611C}"/>
              </a:ext>
            </a:extLst>
          </p:cNvPr>
          <p:cNvSpPr txBox="1"/>
          <p:nvPr/>
        </p:nvSpPr>
        <p:spPr>
          <a:xfrm>
            <a:off x="118986" y="3121223"/>
            <a:ext cx="87013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Figure S4.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The peanut TIR-NBS-LRR homolog in the QTL region is a potential candidate gene in the region of </a:t>
            </a:r>
            <a:r>
              <a:rPr lang="en-US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PSWDR-1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. 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22058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0C98DB4-2199-4AFF-3CB8-87F55924329A}"/>
              </a:ext>
            </a:extLst>
          </p:cNvPr>
          <p:cNvSpPr txBox="1"/>
          <p:nvPr/>
        </p:nvSpPr>
        <p:spPr>
          <a:xfrm>
            <a:off x="336235" y="5088852"/>
            <a:ext cx="845825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A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Phylogenetic analysis of NBS-LRR homologs from seven different plant species. A phylogenetic tree was constructed using the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RAxML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method with the ETE3 toolkit, following sequence alignment with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ClustalW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[61]. Sw5b from Tomato (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olanum </a:t>
            </a:r>
            <a:r>
              <a:rPr lang="en-US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lycopersicu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 was included as a reference. The species abbreviations for the other proteins are: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Nicotiana </a:t>
            </a:r>
            <a:r>
              <a:rPr lang="en-US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glutinosa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Nicgu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,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Arabidopsis thaliana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Arath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,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Vitis rotundifolia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Vitro),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Nicotiana </a:t>
            </a:r>
            <a:r>
              <a:rPr lang="en-US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benthamiana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Nicbe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,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olanum </a:t>
            </a:r>
            <a:r>
              <a:rPr lang="en-US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lycopersicu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ollc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,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olanum </a:t>
            </a:r>
            <a:r>
              <a:rPr lang="en-US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bulbocastanu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olbu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,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Arachis hypogaea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Arahy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), and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Linum </a:t>
            </a:r>
            <a:r>
              <a:rPr lang="en-US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usitatissimum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(Linus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97" name="Graphic 95">
            <a:extLst>
              <a:ext uri="{FF2B5EF4-FFF2-40B4-BE49-F238E27FC236}">
                <a16:creationId xmlns:a16="http://schemas.microsoft.com/office/drawing/2014/main" id="{93D89023-03C1-0817-1BE1-F9B131B3A609}"/>
              </a:ext>
            </a:extLst>
          </p:cNvPr>
          <p:cNvGrpSpPr/>
          <p:nvPr/>
        </p:nvGrpSpPr>
        <p:grpSpPr>
          <a:xfrm>
            <a:off x="1317874" y="582082"/>
            <a:ext cx="5750394" cy="4197763"/>
            <a:chOff x="1317874" y="552265"/>
            <a:chExt cx="5750394" cy="4197763"/>
          </a:xfrm>
        </p:grpSpPr>
        <p:sp>
          <p:nvSpPr>
            <p:cNvPr id="98" name="Freeform: Shape 97">
              <a:extLst>
                <a:ext uri="{FF2B5EF4-FFF2-40B4-BE49-F238E27FC236}">
                  <a16:creationId xmlns:a16="http://schemas.microsoft.com/office/drawing/2014/main" id="{EE95B484-DE56-A727-B55E-36C2BBAD814B}"/>
                </a:ext>
              </a:extLst>
            </p:cNvPr>
            <p:cNvSpPr/>
            <p:nvPr/>
          </p:nvSpPr>
          <p:spPr>
            <a:xfrm>
              <a:off x="1357991" y="681000"/>
              <a:ext cx="4457423" cy="696472"/>
            </a:xfrm>
            <a:custGeom>
              <a:avLst/>
              <a:gdLst>
                <a:gd name="connsiteX0" fmla="*/ 120 w 4457423"/>
                <a:gd name="connsiteY0" fmla="*/ 696492 h 696472"/>
                <a:gd name="connsiteX1" fmla="*/ 120 w 4457423"/>
                <a:gd name="connsiteY1" fmla="*/ 20 h 696472"/>
                <a:gd name="connsiteX2" fmla="*/ 4457544 w 4457423"/>
                <a:gd name="connsiteY2" fmla="*/ 20 h 6964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4457423" h="696472">
                  <a:moveTo>
                    <a:pt x="120" y="696492"/>
                  </a:moveTo>
                  <a:lnTo>
                    <a:pt x="120" y="20"/>
                  </a:lnTo>
                  <a:lnTo>
                    <a:pt x="4457544" y="20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Freeform: Shape 98">
              <a:extLst>
                <a:ext uri="{FF2B5EF4-FFF2-40B4-BE49-F238E27FC236}">
                  <a16:creationId xmlns:a16="http://schemas.microsoft.com/office/drawing/2014/main" id="{B8770E7F-BC89-53D2-1DB1-D4BC43B75AA7}"/>
                </a:ext>
              </a:extLst>
            </p:cNvPr>
            <p:cNvSpPr/>
            <p:nvPr/>
          </p:nvSpPr>
          <p:spPr>
            <a:xfrm>
              <a:off x="1357991" y="1377473"/>
              <a:ext cx="2986268" cy="696472"/>
            </a:xfrm>
            <a:custGeom>
              <a:avLst/>
              <a:gdLst>
                <a:gd name="connsiteX0" fmla="*/ 120 w 2986268"/>
                <a:gd name="connsiteY0" fmla="*/ 20 h 696472"/>
                <a:gd name="connsiteX1" fmla="*/ 120 w 2986268"/>
                <a:gd name="connsiteY1" fmla="*/ 696492 h 696472"/>
                <a:gd name="connsiteX2" fmla="*/ 2986389 w 2986268"/>
                <a:gd name="connsiteY2" fmla="*/ 696492 h 6964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986268" h="696472">
                  <a:moveTo>
                    <a:pt x="120" y="20"/>
                  </a:moveTo>
                  <a:lnTo>
                    <a:pt x="120" y="696492"/>
                  </a:lnTo>
                  <a:lnTo>
                    <a:pt x="2986389" y="696492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Freeform: Shape 99">
              <a:extLst>
                <a:ext uri="{FF2B5EF4-FFF2-40B4-BE49-F238E27FC236}">
                  <a16:creationId xmlns:a16="http://schemas.microsoft.com/office/drawing/2014/main" id="{A3F2D6AD-F57B-A42D-F548-DFF222C0220C}"/>
                </a:ext>
              </a:extLst>
            </p:cNvPr>
            <p:cNvSpPr/>
            <p:nvPr/>
          </p:nvSpPr>
          <p:spPr>
            <a:xfrm>
              <a:off x="4344260" y="1238178"/>
              <a:ext cx="221106" cy="835766"/>
            </a:xfrm>
            <a:custGeom>
              <a:avLst/>
              <a:gdLst>
                <a:gd name="connsiteX0" fmla="*/ 120 w 221106"/>
                <a:gd name="connsiteY0" fmla="*/ 835787 h 835766"/>
                <a:gd name="connsiteX1" fmla="*/ 120 w 221106"/>
                <a:gd name="connsiteY1" fmla="*/ 20 h 835766"/>
                <a:gd name="connsiteX2" fmla="*/ 221226 w 221106"/>
                <a:gd name="connsiteY2" fmla="*/ 20 h 8357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21106" h="835766">
                  <a:moveTo>
                    <a:pt x="120" y="835787"/>
                  </a:moveTo>
                  <a:lnTo>
                    <a:pt x="120" y="20"/>
                  </a:lnTo>
                  <a:lnTo>
                    <a:pt x="221226" y="20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Freeform: Shape 100">
              <a:extLst>
                <a:ext uri="{FF2B5EF4-FFF2-40B4-BE49-F238E27FC236}">
                  <a16:creationId xmlns:a16="http://schemas.microsoft.com/office/drawing/2014/main" id="{3A2B4F8F-D328-9AA6-1060-FE0EFC4DCA41}"/>
                </a:ext>
              </a:extLst>
            </p:cNvPr>
            <p:cNvSpPr/>
            <p:nvPr/>
          </p:nvSpPr>
          <p:spPr>
            <a:xfrm>
              <a:off x="4344260" y="2073945"/>
              <a:ext cx="289670" cy="835766"/>
            </a:xfrm>
            <a:custGeom>
              <a:avLst/>
              <a:gdLst>
                <a:gd name="connsiteX0" fmla="*/ 120 w 289670"/>
                <a:gd name="connsiteY0" fmla="*/ 20 h 835766"/>
                <a:gd name="connsiteX1" fmla="*/ 120 w 289670"/>
                <a:gd name="connsiteY1" fmla="*/ 835787 h 835766"/>
                <a:gd name="connsiteX2" fmla="*/ 289790 w 289670"/>
                <a:gd name="connsiteY2" fmla="*/ 835787 h 8357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89670" h="835766">
                  <a:moveTo>
                    <a:pt x="120" y="20"/>
                  </a:moveTo>
                  <a:lnTo>
                    <a:pt x="120" y="835787"/>
                  </a:lnTo>
                  <a:lnTo>
                    <a:pt x="289790" y="835787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Freeform: Shape 101">
              <a:extLst>
                <a:ext uri="{FF2B5EF4-FFF2-40B4-BE49-F238E27FC236}">
                  <a16:creationId xmlns:a16="http://schemas.microsoft.com/office/drawing/2014/main" id="{FD74C014-217B-8A60-75FF-E77E1757C2EE}"/>
                </a:ext>
              </a:extLst>
            </p:cNvPr>
            <p:cNvSpPr/>
            <p:nvPr/>
          </p:nvSpPr>
          <p:spPr>
            <a:xfrm>
              <a:off x="4633930" y="2073945"/>
              <a:ext cx="73556" cy="835766"/>
            </a:xfrm>
            <a:custGeom>
              <a:avLst/>
              <a:gdLst>
                <a:gd name="connsiteX0" fmla="*/ 120 w 73556"/>
                <a:gd name="connsiteY0" fmla="*/ 835787 h 835766"/>
                <a:gd name="connsiteX1" fmla="*/ 120 w 73556"/>
                <a:gd name="connsiteY1" fmla="*/ 20 h 835766"/>
                <a:gd name="connsiteX2" fmla="*/ 73676 w 73556"/>
                <a:gd name="connsiteY2" fmla="*/ 20 h 8357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3556" h="835766">
                  <a:moveTo>
                    <a:pt x="120" y="835787"/>
                  </a:moveTo>
                  <a:lnTo>
                    <a:pt x="120" y="20"/>
                  </a:lnTo>
                  <a:lnTo>
                    <a:pt x="73676" y="20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Freeform: Shape 102">
              <a:extLst>
                <a:ext uri="{FF2B5EF4-FFF2-40B4-BE49-F238E27FC236}">
                  <a16:creationId xmlns:a16="http://schemas.microsoft.com/office/drawing/2014/main" id="{199644A4-1ECC-2887-9734-4583DA8CE4D4}"/>
                </a:ext>
              </a:extLst>
            </p:cNvPr>
            <p:cNvSpPr/>
            <p:nvPr/>
          </p:nvSpPr>
          <p:spPr>
            <a:xfrm>
              <a:off x="4633930" y="2909712"/>
              <a:ext cx="32797" cy="835766"/>
            </a:xfrm>
            <a:custGeom>
              <a:avLst/>
              <a:gdLst>
                <a:gd name="connsiteX0" fmla="*/ 120 w 32797"/>
                <a:gd name="connsiteY0" fmla="*/ 20 h 835766"/>
                <a:gd name="connsiteX1" fmla="*/ 120 w 32797"/>
                <a:gd name="connsiteY1" fmla="*/ 835787 h 835766"/>
                <a:gd name="connsiteX2" fmla="*/ 32918 w 32797"/>
                <a:gd name="connsiteY2" fmla="*/ 835787 h 83576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2797" h="835766">
                  <a:moveTo>
                    <a:pt x="120" y="20"/>
                  </a:moveTo>
                  <a:lnTo>
                    <a:pt x="120" y="835787"/>
                  </a:lnTo>
                  <a:lnTo>
                    <a:pt x="32918" y="835787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Freeform: Shape 103">
              <a:extLst>
                <a:ext uri="{FF2B5EF4-FFF2-40B4-BE49-F238E27FC236}">
                  <a16:creationId xmlns:a16="http://schemas.microsoft.com/office/drawing/2014/main" id="{061D4113-8A39-D1E6-A5B0-722C58605D42}"/>
                </a:ext>
              </a:extLst>
            </p:cNvPr>
            <p:cNvSpPr/>
            <p:nvPr/>
          </p:nvSpPr>
          <p:spPr>
            <a:xfrm>
              <a:off x="4666728" y="3188301"/>
              <a:ext cx="302552" cy="557177"/>
            </a:xfrm>
            <a:custGeom>
              <a:avLst/>
              <a:gdLst>
                <a:gd name="connsiteX0" fmla="*/ 120 w 302552"/>
                <a:gd name="connsiteY0" fmla="*/ 557198 h 557177"/>
                <a:gd name="connsiteX1" fmla="*/ 120 w 302552"/>
                <a:gd name="connsiteY1" fmla="*/ 20 h 557177"/>
                <a:gd name="connsiteX2" fmla="*/ 302672 w 302552"/>
                <a:gd name="connsiteY2" fmla="*/ 20 h 5571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02552" h="557177">
                  <a:moveTo>
                    <a:pt x="120" y="557198"/>
                  </a:moveTo>
                  <a:lnTo>
                    <a:pt x="120" y="20"/>
                  </a:lnTo>
                  <a:lnTo>
                    <a:pt x="302672" y="20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Freeform: Shape 104">
              <a:extLst>
                <a:ext uri="{FF2B5EF4-FFF2-40B4-BE49-F238E27FC236}">
                  <a16:creationId xmlns:a16="http://schemas.microsoft.com/office/drawing/2014/main" id="{3F4C94A1-0F69-16EB-550B-20CA9DF42FCC}"/>
                </a:ext>
              </a:extLst>
            </p:cNvPr>
            <p:cNvSpPr/>
            <p:nvPr/>
          </p:nvSpPr>
          <p:spPr>
            <a:xfrm>
              <a:off x="4666728" y="3745479"/>
              <a:ext cx="231741" cy="557177"/>
            </a:xfrm>
            <a:custGeom>
              <a:avLst/>
              <a:gdLst>
                <a:gd name="connsiteX0" fmla="*/ 120 w 231741"/>
                <a:gd name="connsiteY0" fmla="*/ 20 h 557177"/>
                <a:gd name="connsiteX1" fmla="*/ 120 w 231741"/>
                <a:gd name="connsiteY1" fmla="*/ 557198 h 557177"/>
                <a:gd name="connsiteX2" fmla="*/ 231862 w 231741"/>
                <a:gd name="connsiteY2" fmla="*/ 557198 h 5571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31741" h="557177">
                  <a:moveTo>
                    <a:pt x="120" y="20"/>
                  </a:moveTo>
                  <a:lnTo>
                    <a:pt x="120" y="557198"/>
                  </a:lnTo>
                  <a:lnTo>
                    <a:pt x="231862" y="557198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Freeform: Shape 105">
              <a:extLst>
                <a:ext uri="{FF2B5EF4-FFF2-40B4-BE49-F238E27FC236}">
                  <a16:creationId xmlns:a16="http://schemas.microsoft.com/office/drawing/2014/main" id="{3E794140-80CE-A85C-E057-9C1EF81A5595}"/>
                </a:ext>
              </a:extLst>
            </p:cNvPr>
            <p:cNvSpPr/>
            <p:nvPr/>
          </p:nvSpPr>
          <p:spPr>
            <a:xfrm>
              <a:off x="4898470" y="4024068"/>
              <a:ext cx="916945" cy="278588"/>
            </a:xfrm>
            <a:custGeom>
              <a:avLst/>
              <a:gdLst>
                <a:gd name="connsiteX0" fmla="*/ 120 w 916945"/>
                <a:gd name="connsiteY0" fmla="*/ 278609 h 278588"/>
                <a:gd name="connsiteX1" fmla="*/ 120 w 916945"/>
                <a:gd name="connsiteY1" fmla="*/ 20 h 278588"/>
                <a:gd name="connsiteX2" fmla="*/ 917066 w 916945"/>
                <a:gd name="connsiteY2" fmla="*/ 20 h 2785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16945" h="278588">
                  <a:moveTo>
                    <a:pt x="120" y="278609"/>
                  </a:moveTo>
                  <a:lnTo>
                    <a:pt x="120" y="20"/>
                  </a:lnTo>
                  <a:lnTo>
                    <a:pt x="917066" y="20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Freeform: Shape 106">
              <a:extLst>
                <a:ext uri="{FF2B5EF4-FFF2-40B4-BE49-F238E27FC236}">
                  <a16:creationId xmlns:a16="http://schemas.microsoft.com/office/drawing/2014/main" id="{D5A0202A-28C5-AAC7-B7AE-CFCC30C539C0}"/>
                </a:ext>
              </a:extLst>
            </p:cNvPr>
            <p:cNvSpPr/>
            <p:nvPr/>
          </p:nvSpPr>
          <p:spPr>
            <a:xfrm>
              <a:off x="4898470" y="4302657"/>
              <a:ext cx="727531" cy="278588"/>
            </a:xfrm>
            <a:custGeom>
              <a:avLst/>
              <a:gdLst>
                <a:gd name="connsiteX0" fmla="*/ 120 w 727531"/>
                <a:gd name="connsiteY0" fmla="*/ 20 h 278588"/>
                <a:gd name="connsiteX1" fmla="*/ 120 w 727531"/>
                <a:gd name="connsiteY1" fmla="*/ 278609 h 278588"/>
                <a:gd name="connsiteX2" fmla="*/ 727652 w 727531"/>
                <a:gd name="connsiteY2" fmla="*/ 278609 h 2785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727531" h="278588">
                  <a:moveTo>
                    <a:pt x="120" y="20"/>
                  </a:moveTo>
                  <a:lnTo>
                    <a:pt x="120" y="278609"/>
                  </a:lnTo>
                  <a:lnTo>
                    <a:pt x="727652" y="278609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Freeform: Shape 107">
              <a:extLst>
                <a:ext uri="{FF2B5EF4-FFF2-40B4-BE49-F238E27FC236}">
                  <a16:creationId xmlns:a16="http://schemas.microsoft.com/office/drawing/2014/main" id="{D3825FB1-B0EC-C25D-52D3-B4B29E6F524A}"/>
                </a:ext>
              </a:extLst>
            </p:cNvPr>
            <p:cNvSpPr/>
            <p:nvPr/>
          </p:nvSpPr>
          <p:spPr>
            <a:xfrm>
              <a:off x="4969280" y="2909712"/>
              <a:ext cx="25630" cy="278588"/>
            </a:xfrm>
            <a:custGeom>
              <a:avLst/>
              <a:gdLst>
                <a:gd name="connsiteX0" fmla="*/ 120 w 25630"/>
                <a:gd name="connsiteY0" fmla="*/ 278609 h 278588"/>
                <a:gd name="connsiteX1" fmla="*/ 120 w 25630"/>
                <a:gd name="connsiteY1" fmla="*/ 20 h 278588"/>
                <a:gd name="connsiteX2" fmla="*/ 25750 w 25630"/>
                <a:gd name="connsiteY2" fmla="*/ 20 h 2785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630" h="278588">
                  <a:moveTo>
                    <a:pt x="120" y="278609"/>
                  </a:moveTo>
                  <a:lnTo>
                    <a:pt x="120" y="20"/>
                  </a:lnTo>
                  <a:lnTo>
                    <a:pt x="25750" y="20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Freeform: Shape 108">
              <a:extLst>
                <a:ext uri="{FF2B5EF4-FFF2-40B4-BE49-F238E27FC236}">
                  <a16:creationId xmlns:a16="http://schemas.microsoft.com/office/drawing/2014/main" id="{71BADABE-16A4-B3C9-7FED-CB12E2DF61DB}"/>
                </a:ext>
              </a:extLst>
            </p:cNvPr>
            <p:cNvSpPr/>
            <p:nvPr/>
          </p:nvSpPr>
          <p:spPr>
            <a:xfrm>
              <a:off x="4969280" y="3188301"/>
              <a:ext cx="20869" cy="278588"/>
            </a:xfrm>
            <a:custGeom>
              <a:avLst/>
              <a:gdLst>
                <a:gd name="connsiteX0" fmla="*/ 120 w 20869"/>
                <a:gd name="connsiteY0" fmla="*/ 20 h 278588"/>
                <a:gd name="connsiteX1" fmla="*/ 120 w 20869"/>
                <a:gd name="connsiteY1" fmla="*/ 278609 h 278588"/>
                <a:gd name="connsiteX2" fmla="*/ 20990 w 20869"/>
                <a:gd name="connsiteY2" fmla="*/ 278609 h 2785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869" h="278588">
                  <a:moveTo>
                    <a:pt x="120" y="20"/>
                  </a:moveTo>
                  <a:lnTo>
                    <a:pt x="120" y="278609"/>
                  </a:lnTo>
                  <a:lnTo>
                    <a:pt x="20990" y="278609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Freeform: Shape 109">
              <a:extLst>
                <a:ext uri="{FF2B5EF4-FFF2-40B4-BE49-F238E27FC236}">
                  <a16:creationId xmlns:a16="http://schemas.microsoft.com/office/drawing/2014/main" id="{441660E1-02FF-944C-5625-1E2502979084}"/>
                </a:ext>
              </a:extLst>
            </p:cNvPr>
            <p:cNvSpPr/>
            <p:nvPr/>
          </p:nvSpPr>
          <p:spPr>
            <a:xfrm>
              <a:off x="4707487" y="1795356"/>
              <a:ext cx="336499" cy="278588"/>
            </a:xfrm>
            <a:custGeom>
              <a:avLst/>
              <a:gdLst>
                <a:gd name="connsiteX0" fmla="*/ 120 w 336499"/>
                <a:gd name="connsiteY0" fmla="*/ 278609 h 278588"/>
                <a:gd name="connsiteX1" fmla="*/ 120 w 336499"/>
                <a:gd name="connsiteY1" fmla="*/ 20 h 278588"/>
                <a:gd name="connsiteX2" fmla="*/ 336620 w 336499"/>
                <a:gd name="connsiteY2" fmla="*/ 20 h 2785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36499" h="278588">
                  <a:moveTo>
                    <a:pt x="120" y="278609"/>
                  </a:moveTo>
                  <a:lnTo>
                    <a:pt x="120" y="20"/>
                  </a:lnTo>
                  <a:lnTo>
                    <a:pt x="336620" y="20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Freeform: Shape 110">
              <a:extLst>
                <a:ext uri="{FF2B5EF4-FFF2-40B4-BE49-F238E27FC236}">
                  <a16:creationId xmlns:a16="http://schemas.microsoft.com/office/drawing/2014/main" id="{129CC55D-9B51-8DFF-90CB-0484466F2296}"/>
                </a:ext>
              </a:extLst>
            </p:cNvPr>
            <p:cNvSpPr/>
            <p:nvPr/>
          </p:nvSpPr>
          <p:spPr>
            <a:xfrm>
              <a:off x="4707487" y="2073945"/>
              <a:ext cx="358439" cy="278588"/>
            </a:xfrm>
            <a:custGeom>
              <a:avLst/>
              <a:gdLst>
                <a:gd name="connsiteX0" fmla="*/ 120 w 358439"/>
                <a:gd name="connsiteY0" fmla="*/ 20 h 278588"/>
                <a:gd name="connsiteX1" fmla="*/ 120 w 358439"/>
                <a:gd name="connsiteY1" fmla="*/ 278609 h 278588"/>
                <a:gd name="connsiteX2" fmla="*/ 358559 w 358439"/>
                <a:gd name="connsiteY2" fmla="*/ 278609 h 2785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58439" h="278588">
                  <a:moveTo>
                    <a:pt x="120" y="20"/>
                  </a:moveTo>
                  <a:lnTo>
                    <a:pt x="120" y="278609"/>
                  </a:lnTo>
                  <a:lnTo>
                    <a:pt x="358559" y="278609"/>
                  </a:lnTo>
                </a:path>
              </a:pathLst>
            </a:custGeom>
            <a:noFill/>
            <a:ln w="35645" cap="flat">
              <a:solidFill>
                <a:srgbClr val="AAAAAA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Freeform: Shape 111">
              <a:extLst>
                <a:ext uri="{FF2B5EF4-FFF2-40B4-BE49-F238E27FC236}">
                  <a16:creationId xmlns:a16="http://schemas.microsoft.com/office/drawing/2014/main" id="{1137478D-F81C-C44B-AAEB-A8933AA332DE}"/>
                </a:ext>
              </a:extLst>
            </p:cNvPr>
            <p:cNvSpPr/>
            <p:nvPr/>
          </p:nvSpPr>
          <p:spPr>
            <a:xfrm>
              <a:off x="1317874" y="1337356"/>
              <a:ext cx="80233" cy="80233"/>
            </a:xfrm>
            <a:custGeom>
              <a:avLst/>
              <a:gdLst>
                <a:gd name="connsiteX0" fmla="*/ 80354 w 80233"/>
                <a:gd name="connsiteY0" fmla="*/ 40246 h 80233"/>
                <a:gd name="connsiteX1" fmla="*/ 40237 w 80233"/>
                <a:gd name="connsiteY1" fmla="*/ 80363 h 80233"/>
                <a:gd name="connsiteX2" fmla="*/ 120 w 80233"/>
                <a:gd name="connsiteY2" fmla="*/ 40246 h 80233"/>
                <a:gd name="connsiteX3" fmla="*/ 40237 w 80233"/>
                <a:gd name="connsiteY3" fmla="*/ 129 h 80233"/>
                <a:gd name="connsiteX4" fmla="*/ 80354 w 80233"/>
                <a:gd name="connsiteY4" fmla="*/ 40246 h 802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80233" h="80233">
                  <a:moveTo>
                    <a:pt x="80354" y="40246"/>
                  </a:moveTo>
                  <a:cubicBezTo>
                    <a:pt x="80354" y="62402"/>
                    <a:pt x="62393" y="80363"/>
                    <a:pt x="40237" y="80363"/>
                  </a:cubicBezTo>
                  <a:cubicBezTo>
                    <a:pt x="18081" y="80363"/>
                    <a:pt x="120" y="62402"/>
                    <a:pt x="120" y="40246"/>
                  </a:cubicBezTo>
                  <a:cubicBezTo>
                    <a:pt x="120" y="18090"/>
                    <a:pt x="18081" y="129"/>
                    <a:pt x="40237" y="129"/>
                  </a:cubicBezTo>
                  <a:cubicBezTo>
                    <a:pt x="62393" y="129"/>
                    <a:pt x="80354" y="18090"/>
                    <a:pt x="80354" y="40246"/>
                  </a:cubicBezTo>
                  <a:close/>
                </a:path>
              </a:pathLst>
            </a:custGeom>
            <a:solidFill>
              <a:srgbClr val="FFFFFF"/>
            </a:solidFill>
            <a:ln w="17822" cap="flat">
              <a:solidFill>
                <a:srgbClr val="4682B4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3" name="Graphic 95">
              <a:extLst>
                <a:ext uri="{FF2B5EF4-FFF2-40B4-BE49-F238E27FC236}">
                  <a16:creationId xmlns:a16="http://schemas.microsoft.com/office/drawing/2014/main" id="{400606F9-4CEF-500B-FD22-60BA8032A162}"/>
                </a:ext>
              </a:extLst>
            </p:cNvPr>
            <p:cNvGrpSpPr/>
            <p:nvPr/>
          </p:nvGrpSpPr>
          <p:grpSpPr>
            <a:xfrm>
              <a:off x="4525249" y="1109443"/>
              <a:ext cx="1095932" cy="297517"/>
              <a:chOff x="4525249" y="1109443"/>
              <a:chExt cx="1095932" cy="297517"/>
            </a:xfrm>
          </p:grpSpPr>
          <p:sp>
            <p:nvSpPr>
              <p:cNvPr id="114" name="Freeform: Shape 113">
                <a:extLst>
                  <a:ext uri="{FF2B5EF4-FFF2-40B4-BE49-F238E27FC236}">
                    <a16:creationId xmlns:a16="http://schemas.microsoft.com/office/drawing/2014/main" id="{728C9471-3BC9-BAED-206C-520190F30EFE}"/>
                  </a:ext>
                </a:extLst>
              </p:cNvPr>
              <p:cNvSpPr/>
              <p:nvPr/>
            </p:nvSpPr>
            <p:spPr>
              <a:xfrm>
                <a:off x="4525249" y="1198062"/>
                <a:ext cx="80233" cy="80233"/>
              </a:xfrm>
              <a:custGeom>
                <a:avLst/>
                <a:gdLst>
                  <a:gd name="connsiteX0" fmla="*/ 80713 w 80233"/>
                  <a:gd name="connsiteY0" fmla="*/ 40231 h 80233"/>
                  <a:gd name="connsiteX1" fmla="*/ 40597 w 80233"/>
                  <a:gd name="connsiteY1" fmla="*/ 80347 h 80233"/>
                  <a:gd name="connsiteX2" fmla="*/ 480 w 80233"/>
                  <a:gd name="connsiteY2" fmla="*/ 40231 h 80233"/>
                  <a:gd name="connsiteX3" fmla="*/ 40597 w 80233"/>
                  <a:gd name="connsiteY3" fmla="*/ 114 h 80233"/>
                  <a:gd name="connsiteX4" fmla="*/ 80713 w 80233"/>
                  <a:gd name="connsiteY4" fmla="*/ 40231 h 802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0233" h="80233">
                    <a:moveTo>
                      <a:pt x="80713" y="40231"/>
                    </a:moveTo>
                    <a:cubicBezTo>
                      <a:pt x="80713" y="62386"/>
                      <a:pt x="62753" y="80347"/>
                      <a:pt x="40597" y="80347"/>
                    </a:cubicBezTo>
                    <a:cubicBezTo>
                      <a:pt x="18441" y="80347"/>
                      <a:pt x="480" y="62386"/>
                      <a:pt x="480" y="40231"/>
                    </a:cubicBezTo>
                    <a:cubicBezTo>
                      <a:pt x="480" y="18075"/>
                      <a:pt x="18441" y="114"/>
                      <a:pt x="40597" y="114"/>
                    </a:cubicBezTo>
                    <a:cubicBezTo>
                      <a:pt x="62753" y="114"/>
                      <a:pt x="80713" y="18075"/>
                      <a:pt x="80713" y="40231"/>
                    </a:cubicBezTo>
                    <a:close/>
                  </a:path>
                </a:pathLst>
              </a:custGeom>
              <a:solidFill>
                <a:srgbClr val="FFFFFF"/>
              </a:solidFill>
              <a:ln w="17822" cap="flat">
                <a:solidFill>
                  <a:srgbClr val="4682B4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 sz="2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049E98E9-CD5F-AA38-68A0-54D991C9E164}"/>
                  </a:ext>
                </a:extLst>
              </p:cNvPr>
              <p:cNvSpPr txBox="1"/>
              <p:nvPr/>
            </p:nvSpPr>
            <p:spPr>
              <a:xfrm>
                <a:off x="4545245" y="1109443"/>
                <a:ext cx="1075936" cy="297517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pPr algn="l"/>
                <a:r>
                  <a:rPr lang="en-US" sz="2000" spc="0" baseline="20000">
                    <a:ln/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ourier New"/>
                    <a:rtl val="0"/>
                  </a:rPr>
                  <a:t>Arath_Dsc1</a:t>
                </a:r>
              </a:p>
            </p:txBody>
          </p:sp>
        </p:grpSp>
        <p:grpSp>
          <p:nvGrpSpPr>
            <p:cNvPr id="116" name="Graphic 95">
              <a:extLst>
                <a:ext uri="{FF2B5EF4-FFF2-40B4-BE49-F238E27FC236}">
                  <a16:creationId xmlns:a16="http://schemas.microsoft.com/office/drawing/2014/main" id="{F560C59D-8AA8-AAB3-933A-913F7F4E5CCF}"/>
                </a:ext>
              </a:extLst>
            </p:cNvPr>
            <p:cNvGrpSpPr/>
            <p:nvPr/>
          </p:nvGrpSpPr>
          <p:grpSpPr>
            <a:xfrm>
              <a:off x="5775298" y="3895333"/>
              <a:ext cx="895557" cy="297517"/>
              <a:chOff x="5775298" y="3895333"/>
              <a:chExt cx="895557" cy="297517"/>
            </a:xfrm>
          </p:grpSpPr>
          <p:sp>
            <p:nvSpPr>
              <p:cNvPr id="117" name="Freeform: Shape 116">
                <a:extLst>
                  <a:ext uri="{FF2B5EF4-FFF2-40B4-BE49-F238E27FC236}">
                    <a16:creationId xmlns:a16="http://schemas.microsoft.com/office/drawing/2014/main" id="{E28512D9-8FBA-D8CA-90D8-853FCE057BDC}"/>
                  </a:ext>
                </a:extLst>
              </p:cNvPr>
              <p:cNvSpPr/>
              <p:nvPr/>
            </p:nvSpPr>
            <p:spPr>
              <a:xfrm>
                <a:off x="5775298" y="3983951"/>
                <a:ext cx="80233" cy="80233"/>
              </a:xfrm>
              <a:custGeom>
                <a:avLst/>
                <a:gdLst>
                  <a:gd name="connsiteX0" fmla="*/ 80854 w 80233"/>
                  <a:gd name="connsiteY0" fmla="*/ 40543 h 80233"/>
                  <a:gd name="connsiteX1" fmla="*/ 40737 w 80233"/>
                  <a:gd name="connsiteY1" fmla="*/ 80660 h 80233"/>
                  <a:gd name="connsiteX2" fmla="*/ 620 w 80233"/>
                  <a:gd name="connsiteY2" fmla="*/ 40543 h 80233"/>
                  <a:gd name="connsiteX3" fmla="*/ 40737 w 80233"/>
                  <a:gd name="connsiteY3" fmla="*/ 426 h 80233"/>
                  <a:gd name="connsiteX4" fmla="*/ 80854 w 80233"/>
                  <a:gd name="connsiteY4" fmla="*/ 40543 h 802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0233" h="80233">
                    <a:moveTo>
                      <a:pt x="80854" y="40543"/>
                    </a:moveTo>
                    <a:cubicBezTo>
                      <a:pt x="80854" y="62699"/>
                      <a:pt x="62893" y="80660"/>
                      <a:pt x="40737" y="80660"/>
                    </a:cubicBezTo>
                    <a:cubicBezTo>
                      <a:pt x="18581" y="80660"/>
                      <a:pt x="620" y="62699"/>
                      <a:pt x="620" y="40543"/>
                    </a:cubicBezTo>
                    <a:cubicBezTo>
                      <a:pt x="620" y="18387"/>
                      <a:pt x="18581" y="426"/>
                      <a:pt x="40737" y="426"/>
                    </a:cubicBezTo>
                    <a:cubicBezTo>
                      <a:pt x="62893" y="426"/>
                      <a:pt x="80854" y="18387"/>
                      <a:pt x="80854" y="40543"/>
                    </a:cubicBezTo>
                    <a:close/>
                  </a:path>
                </a:pathLst>
              </a:custGeom>
              <a:solidFill>
                <a:srgbClr val="FFFFFF"/>
              </a:solidFill>
              <a:ln w="17822" cap="flat">
                <a:solidFill>
                  <a:srgbClr val="4682B4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 sz="2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3200ED3D-ECFE-B233-A871-0405ABE6C678}"/>
                  </a:ext>
                </a:extLst>
              </p:cNvPr>
              <p:cNvSpPr txBox="1"/>
              <p:nvPr/>
            </p:nvSpPr>
            <p:spPr>
              <a:xfrm>
                <a:off x="5795294" y="3895333"/>
                <a:ext cx="875561" cy="297517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pPr algn="l"/>
                <a:r>
                  <a:rPr lang="en-US" sz="2000" spc="0" baseline="20000">
                    <a:ln/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ourier New"/>
                    <a:rtl val="0"/>
                  </a:rPr>
                  <a:t>Linus_L6</a:t>
                </a:r>
              </a:p>
            </p:txBody>
          </p:sp>
        </p:grpSp>
        <p:grpSp>
          <p:nvGrpSpPr>
            <p:cNvPr id="119" name="Graphic 95">
              <a:extLst>
                <a:ext uri="{FF2B5EF4-FFF2-40B4-BE49-F238E27FC236}">
                  <a16:creationId xmlns:a16="http://schemas.microsoft.com/office/drawing/2014/main" id="{93E39404-6951-3228-47D9-40E1E68AB8E1}"/>
                </a:ext>
              </a:extLst>
            </p:cNvPr>
            <p:cNvGrpSpPr/>
            <p:nvPr/>
          </p:nvGrpSpPr>
          <p:grpSpPr>
            <a:xfrm>
              <a:off x="5585885" y="4452511"/>
              <a:ext cx="1482383" cy="297517"/>
              <a:chOff x="5585885" y="4452511"/>
              <a:chExt cx="1482383" cy="297517"/>
            </a:xfrm>
          </p:grpSpPr>
          <p:sp>
            <p:nvSpPr>
              <p:cNvPr id="120" name="Freeform: Shape 119">
                <a:extLst>
                  <a:ext uri="{FF2B5EF4-FFF2-40B4-BE49-F238E27FC236}">
                    <a16:creationId xmlns:a16="http://schemas.microsoft.com/office/drawing/2014/main" id="{FDBB7AAE-E891-EBE6-71FC-8E85F9D2F71C}"/>
                  </a:ext>
                </a:extLst>
              </p:cNvPr>
              <p:cNvSpPr/>
              <p:nvPr/>
            </p:nvSpPr>
            <p:spPr>
              <a:xfrm>
                <a:off x="5585885" y="4541129"/>
                <a:ext cx="80233" cy="80233"/>
              </a:xfrm>
              <a:custGeom>
                <a:avLst/>
                <a:gdLst>
                  <a:gd name="connsiteX0" fmla="*/ 80832 w 80233"/>
                  <a:gd name="connsiteY0" fmla="*/ 40606 h 80233"/>
                  <a:gd name="connsiteX1" fmla="*/ 40716 w 80233"/>
                  <a:gd name="connsiteY1" fmla="*/ 80722 h 80233"/>
                  <a:gd name="connsiteX2" fmla="*/ 599 w 80233"/>
                  <a:gd name="connsiteY2" fmla="*/ 40606 h 80233"/>
                  <a:gd name="connsiteX3" fmla="*/ 40716 w 80233"/>
                  <a:gd name="connsiteY3" fmla="*/ 489 h 80233"/>
                  <a:gd name="connsiteX4" fmla="*/ 80832 w 80233"/>
                  <a:gd name="connsiteY4" fmla="*/ 40606 h 802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0233" h="80233">
                    <a:moveTo>
                      <a:pt x="80832" y="40606"/>
                    </a:moveTo>
                    <a:cubicBezTo>
                      <a:pt x="80832" y="62761"/>
                      <a:pt x="62871" y="80722"/>
                      <a:pt x="40716" y="80722"/>
                    </a:cubicBezTo>
                    <a:cubicBezTo>
                      <a:pt x="18560" y="80722"/>
                      <a:pt x="599" y="62761"/>
                      <a:pt x="599" y="40606"/>
                    </a:cubicBezTo>
                    <a:cubicBezTo>
                      <a:pt x="599" y="18450"/>
                      <a:pt x="18560" y="489"/>
                      <a:pt x="40716" y="489"/>
                    </a:cubicBezTo>
                    <a:cubicBezTo>
                      <a:pt x="62871" y="489"/>
                      <a:pt x="80832" y="18450"/>
                      <a:pt x="80832" y="40606"/>
                    </a:cubicBezTo>
                    <a:close/>
                  </a:path>
                </a:pathLst>
              </a:custGeom>
              <a:solidFill>
                <a:srgbClr val="FFFFFF"/>
              </a:solidFill>
              <a:ln w="17822" cap="flat">
                <a:solidFill>
                  <a:srgbClr val="4682B4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 sz="2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DB70C242-0770-6652-22C7-3F0DF10FFCF3}"/>
                  </a:ext>
                </a:extLst>
              </p:cNvPr>
              <p:cNvSpPr txBox="1"/>
              <p:nvPr/>
            </p:nvSpPr>
            <p:spPr>
              <a:xfrm>
                <a:off x="5605880" y="4452511"/>
                <a:ext cx="1462388" cy="297517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pPr algn="l"/>
                <a:r>
                  <a:rPr lang="en-US" sz="2000" spc="0" baseline="20000">
                    <a:ln/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ourier New"/>
                    <a:rtl val="0"/>
                  </a:rPr>
                  <a:t>Arahy.1PK53M.1</a:t>
                </a:r>
              </a:p>
            </p:txBody>
          </p:sp>
        </p:grpSp>
        <p:grpSp>
          <p:nvGrpSpPr>
            <p:cNvPr id="122" name="Graphic 95">
              <a:extLst>
                <a:ext uri="{FF2B5EF4-FFF2-40B4-BE49-F238E27FC236}">
                  <a16:creationId xmlns:a16="http://schemas.microsoft.com/office/drawing/2014/main" id="{ABEC1E3C-7F0F-1627-B02A-7F7E97062632}"/>
                </a:ext>
              </a:extLst>
            </p:cNvPr>
            <p:cNvGrpSpPr/>
            <p:nvPr/>
          </p:nvGrpSpPr>
          <p:grpSpPr>
            <a:xfrm>
              <a:off x="4954794" y="2780977"/>
              <a:ext cx="1046366" cy="297517"/>
              <a:chOff x="4954794" y="2780977"/>
              <a:chExt cx="1046366" cy="297517"/>
            </a:xfrm>
          </p:grpSpPr>
          <p:sp>
            <p:nvSpPr>
              <p:cNvPr id="123" name="Freeform: Shape 122">
                <a:extLst>
                  <a:ext uri="{FF2B5EF4-FFF2-40B4-BE49-F238E27FC236}">
                    <a16:creationId xmlns:a16="http://schemas.microsoft.com/office/drawing/2014/main" id="{C65289C0-5365-FE92-B373-077E99A01FF8}"/>
                  </a:ext>
                </a:extLst>
              </p:cNvPr>
              <p:cNvSpPr/>
              <p:nvPr/>
            </p:nvSpPr>
            <p:spPr>
              <a:xfrm>
                <a:off x="4954794" y="2869595"/>
                <a:ext cx="80233" cy="80233"/>
              </a:xfrm>
              <a:custGeom>
                <a:avLst/>
                <a:gdLst>
                  <a:gd name="connsiteX0" fmla="*/ 80762 w 80233"/>
                  <a:gd name="connsiteY0" fmla="*/ 40418 h 80233"/>
                  <a:gd name="connsiteX1" fmla="*/ 40645 w 80233"/>
                  <a:gd name="connsiteY1" fmla="*/ 80535 h 80233"/>
                  <a:gd name="connsiteX2" fmla="*/ 528 w 80233"/>
                  <a:gd name="connsiteY2" fmla="*/ 40418 h 80233"/>
                  <a:gd name="connsiteX3" fmla="*/ 40645 w 80233"/>
                  <a:gd name="connsiteY3" fmla="*/ 301 h 80233"/>
                  <a:gd name="connsiteX4" fmla="*/ 80762 w 80233"/>
                  <a:gd name="connsiteY4" fmla="*/ 40418 h 802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0233" h="80233">
                    <a:moveTo>
                      <a:pt x="80762" y="40418"/>
                    </a:moveTo>
                    <a:cubicBezTo>
                      <a:pt x="80762" y="62574"/>
                      <a:pt x="62801" y="80535"/>
                      <a:pt x="40645" y="80535"/>
                    </a:cubicBezTo>
                    <a:cubicBezTo>
                      <a:pt x="18489" y="80535"/>
                      <a:pt x="528" y="62574"/>
                      <a:pt x="528" y="40418"/>
                    </a:cubicBezTo>
                    <a:cubicBezTo>
                      <a:pt x="528" y="18262"/>
                      <a:pt x="18489" y="301"/>
                      <a:pt x="40645" y="301"/>
                    </a:cubicBezTo>
                    <a:cubicBezTo>
                      <a:pt x="62801" y="301"/>
                      <a:pt x="80762" y="18262"/>
                      <a:pt x="80762" y="40418"/>
                    </a:cubicBezTo>
                    <a:close/>
                  </a:path>
                </a:pathLst>
              </a:custGeom>
              <a:solidFill>
                <a:srgbClr val="FFFFFF"/>
              </a:solidFill>
              <a:ln w="17822" cap="flat">
                <a:solidFill>
                  <a:srgbClr val="4682B4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 sz="2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C0EFB618-2F66-E21D-7F58-26C8F0E32DEE}"/>
                  </a:ext>
                </a:extLst>
              </p:cNvPr>
              <p:cNvSpPr txBox="1"/>
              <p:nvPr/>
            </p:nvSpPr>
            <p:spPr>
              <a:xfrm>
                <a:off x="4974789" y="2780977"/>
                <a:ext cx="1026371" cy="297517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pPr algn="l"/>
                <a:r>
                  <a:rPr lang="en-US" sz="2000" spc="0" baseline="20000">
                    <a:ln/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ourier New"/>
                    <a:rtl val="0"/>
                  </a:rPr>
                  <a:t>Vitro_Rpv1</a:t>
                </a:r>
              </a:p>
            </p:txBody>
          </p:sp>
        </p:grpSp>
        <p:grpSp>
          <p:nvGrpSpPr>
            <p:cNvPr id="125" name="Graphic 95">
              <a:extLst>
                <a:ext uri="{FF2B5EF4-FFF2-40B4-BE49-F238E27FC236}">
                  <a16:creationId xmlns:a16="http://schemas.microsoft.com/office/drawing/2014/main" id="{2BCCF48C-A835-812D-6506-9C12CDE4B3F0}"/>
                </a:ext>
              </a:extLst>
            </p:cNvPr>
            <p:cNvGrpSpPr/>
            <p:nvPr/>
          </p:nvGrpSpPr>
          <p:grpSpPr>
            <a:xfrm>
              <a:off x="4950033" y="3338155"/>
              <a:ext cx="1055985" cy="297517"/>
              <a:chOff x="4950033" y="3338155"/>
              <a:chExt cx="1055985" cy="297517"/>
            </a:xfrm>
          </p:grpSpPr>
          <p:sp>
            <p:nvSpPr>
              <p:cNvPr id="126" name="Freeform: Shape 125">
                <a:extLst>
                  <a:ext uri="{FF2B5EF4-FFF2-40B4-BE49-F238E27FC236}">
                    <a16:creationId xmlns:a16="http://schemas.microsoft.com/office/drawing/2014/main" id="{B995A7A4-2563-6A42-879B-B8BCACBF0425}"/>
                  </a:ext>
                </a:extLst>
              </p:cNvPr>
              <p:cNvSpPr/>
              <p:nvPr/>
            </p:nvSpPr>
            <p:spPr>
              <a:xfrm>
                <a:off x="4950033" y="3426773"/>
                <a:ext cx="80233" cy="80233"/>
              </a:xfrm>
              <a:custGeom>
                <a:avLst/>
                <a:gdLst>
                  <a:gd name="connsiteX0" fmla="*/ 80761 w 80233"/>
                  <a:gd name="connsiteY0" fmla="*/ 40481 h 80233"/>
                  <a:gd name="connsiteX1" fmla="*/ 40644 w 80233"/>
                  <a:gd name="connsiteY1" fmla="*/ 80597 h 80233"/>
                  <a:gd name="connsiteX2" fmla="*/ 527 w 80233"/>
                  <a:gd name="connsiteY2" fmla="*/ 40481 h 80233"/>
                  <a:gd name="connsiteX3" fmla="*/ 40644 w 80233"/>
                  <a:gd name="connsiteY3" fmla="*/ 364 h 80233"/>
                  <a:gd name="connsiteX4" fmla="*/ 80761 w 80233"/>
                  <a:gd name="connsiteY4" fmla="*/ 40481 h 802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0233" h="80233">
                    <a:moveTo>
                      <a:pt x="80761" y="40481"/>
                    </a:moveTo>
                    <a:cubicBezTo>
                      <a:pt x="80761" y="62636"/>
                      <a:pt x="62800" y="80597"/>
                      <a:pt x="40644" y="80597"/>
                    </a:cubicBezTo>
                    <a:cubicBezTo>
                      <a:pt x="18488" y="80597"/>
                      <a:pt x="527" y="62636"/>
                      <a:pt x="527" y="40481"/>
                    </a:cubicBezTo>
                    <a:cubicBezTo>
                      <a:pt x="527" y="18325"/>
                      <a:pt x="18488" y="364"/>
                      <a:pt x="40644" y="364"/>
                    </a:cubicBezTo>
                    <a:cubicBezTo>
                      <a:pt x="62800" y="364"/>
                      <a:pt x="80761" y="18325"/>
                      <a:pt x="80761" y="40481"/>
                    </a:cubicBezTo>
                    <a:close/>
                  </a:path>
                </a:pathLst>
              </a:custGeom>
              <a:solidFill>
                <a:srgbClr val="FFFFFF"/>
              </a:solidFill>
              <a:ln w="17822" cap="flat">
                <a:solidFill>
                  <a:srgbClr val="4682B4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 sz="2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66C5DD69-DCB4-A077-A74C-BEFF9871FE22}"/>
                  </a:ext>
                </a:extLst>
              </p:cNvPr>
              <p:cNvSpPr txBox="1"/>
              <p:nvPr/>
            </p:nvSpPr>
            <p:spPr>
              <a:xfrm>
                <a:off x="4970029" y="3338155"/>
                <a:ext cx="1035989" cy="297517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pPr algn="l"/>
                <a:r>
                  <a:rPr lang="en-US" sz="2000" spc="0" baseline="20000">
                    <a:ln/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ourier New"/>
                    <a:rtl val="0"/>
                  </a:rPr>
                  <a:t>Vitro_Run1</a:t>
                </a:r>
              </a:p>
            </p:txBody>
          </p:sp>
        </p:grpSp>
        <p:grpSp>
          <p:nvGrpSpPr>
            <p:cNvPr id="128" name="Graphic 95">
              <a:extLst>
                <a:ext uri="{FF2B5EF4-FFF2-40B4-BE49-F238E27FC236}">
                  <a16:creationId xmlns:a16="http://schemas.microsoft.com/office/drawing/2014/main" id="{83D68FEC-1174-01C3-3E3C-2ACACD60747F}"/>
                </a:ext>
              </a:extLst>
            </p:cNvPr>
            <p:cNvGrpSpPr/>
            <p:nvPr/>
          </p:nvGrpSpPr>
          <p:grpSpPr>
            <a:xfrm>
              <a:off x="5003870" y="1666621"/>
              <a:ext cx="1313939" cy="297517"/>
              <a:chOff x="5003870" y="1666621"/>
              <a:chExt cx="1313939" cy="297517"/>
            </a:xfrm>
          </p:grpSpPr>
          <p:sp>
            <p:nvSpPr>
              <p:cNvPr id="129" name="Freeform: Shape 128">
                <a:extLst>
                  <a:ext uri="{FF2B5EF4-FFF2-40B4-BE49-F238E27FC236}">
                    <a16:creationId xmlns:a16="http://schemas.microsoft.com/office/drawing/2014/main" id="{64CDE90F-6857-F662-5966-F25874D39076}"/>
                  </a:ext>
                </a:extLst>
              </p:cNvPr>
              <p:cNvSpPr/>
              <p:nvPr/>
            </p:nvSpPr>
            <p:spPr>
              <a:xfrm>
                <a:off x="5003870" y="1755240"/>
                <a:ext cx="80233" cy="80233"/>
              </a:xfrm>
              <a:custGeom>
                <a:avLst/>
                <a:gdLst>
                  <a:gd name="connsiteX0" fmla="*/ 80767 w 80233"/>
                  <a:gd name="connsiteY0" fmla="*/ 40293 h 80233"/>
                  <a:gd name="connsiteX1" fmla="*/ 40650 w 80233"/>
                  <a:gd name="connsiteY1" fmla="*/ 80410 h 80233"/>
                  <a:gd name="connsiteX2" fmla="*/ 533 w 80233"/>
                  <a:gd name="connsiteY2" fmla="*/ 40293 h 80233"/>
                  <a:gd name="connsiteX3" fmla="*/ 40650 w 80233"/>
                  <a:gd name="connsiteY3" fmla="*/ 176 h 80233"/>
                  <a:gd name="connsiteX4" fmla="*/ 80767 w 80233"/>
                  <a:gd name="connsiteY4" fmla="*/ 40293 h 802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0233" h="80233">
                    <a:moveTo>
                      <a:pt x="80767" y="40293"/>
                    </a:moveTo>
                    <a:cubicBezTo>
                      <a:pt x="80767" y="62449"/>
                      <a:pt x="62806" y="80410"/>
                      <a:pt x="40650" y="80410"/>
                    </a:cubicBezTo>
                    <a:cubicBezTo>
                      <a:pt x="18494" y="80410"/>
                      <a:pt x="533" y="62449"/>
                      <a:pt x="533" y="40293"/>
                    </a:cubicBezTo>
                    <a:cubicBezTo>
                      <a:pt x="533" y="18137"/>
                      <a:pt x="18494" y="176"/>
                      <a:pt x="40650" y="176"/>
                    </a:cubicBezTo>
                    <a:cubicBezTo>
                      <a:pt x="62806" y="176"/>
                      <a:pt x="80767" y="18137"/>
                      <a:pt x="80767" y="40293"/>
                    </a:cubicBezTo>
                    <a:close/>
                  </a:path>
                </a:pathLst>
              </a:custGeom>
              <a:solidFill>
                <a:srgbClr val="FFFFFF"/>
              </a:solidFill>
              <a:ln w="17822" cap="flat">
                <a:solidFill>
                  <a:srgbClr val="4682B4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 sz="2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42C6FEBF-C2AE-2811-2A0E-2D19EE140619}"/>
                  </a:ext>
                </a:extLst>
              </p:cNvPr>
              <p:cNvSpPr txBox="1"/>
              <p:nvPr/>
            </p:nvSpPr>
            <p:spPr>
              <a:xfrm>
                <a:off x="5023865" y="1666621"/>
                <a:ext cx="1293944" cy="297517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pPr algn="l"/>
                <a:r>
                  <a:rPr lang="en-US" sz="2000" spc="0" baseline="20000">
                    <a:ln/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ourier New"/>
                    <a:rtl val="0"/>
                  </a:rPr>
                  <a:t>Nicgu_TmvRN</a:t>
                </a:r>
              </a:p>
            </p:txBody>
          </p:sp>
        </p:grpSp>
        <p:grpSp>
          <p:nvGrpSpPr>
            <p:cNvPr id="131" name="Graphic 95">
              <a:extLst>
                <a:ext uri="{FF2B5EF4-FFF2-40B4-BE49-F238E27FC236}">
                  <a16:creationId xmlns:a16="http://schemas.microsoft.com/office/drawing/2014/main" id="{867200DD-2B06-4079-FA00-963755690959}"/>
                </a:ext>
              </a:extLst>
            </p:cNvPr>
            <p:cNvGrpSpPr/>
            <p:nvPr/>
          </p:nvGrpSpPr>
          <p:grpSpPr>
            <a:xfrm>
              <a:off x="5025809" y="2223799"/>
              <a:ext cx="1142419" cy="297517"/>
              <a:chOff x="5025809" y="2223799"/>
              <a:chExt cx="1142419" cy="297517"/>
            </a:xfrm>
          </p:grpSpPr>
          <p:sp>
            <p:nvSpPr>
              <p:cNvPr id="132" name="Freeform: Shape 131">
                <a:extLst>
                  <a:ext uri="{FF2B5EF4-FFF2-40B4-BE49-F238E27FC236}">
                    <a16:creationId xmlns:a16="http://schemas.microsoft.com/office/drawing/2014/main" id="{3C1F5844-72BF-67FB-74FF-115D0C228D6B}"/>
                  </a:ext>
                </a:extLst>
              </p:cNvPr>
              <p:cNvSpPr/>
              <p:nvPr/>
            </p:nvSpPr>
            <p:spPr>
              <a:xfrm>
                <a:off x="5025809" y="2312417"/>
                <a:ext cx="80233" cy="80233"/>
              </a:xfrm>
              <a:custGeom>
                <a:avLst/>
                <a:gdLst>
                  <a:gd name="connsiteX0" fmla="*/ 80770 w 80233"/>
                  <a:gd name="connsiteY0" fmla="*/ 40356 h 80233"/>
                  <a:gd name="connsiteX1" fmla="*/ 40653 w 80233"/>
                  <a:gd name="connsiteY1" fmla="*/ 80472 h 80233"/>
                  <a:gd name="connsiteX2" fmla="*/ 536 w 80233"/>
                  <a:gd name="connsiteY2" fmla="*/ 40356 h 80233"/>
                  <a:gd name="connsiteX3" fmla="*/ 40653 w 80233"/>
                  <a:gd name="connsiteY3" fmla="*/ 239 h 80233"/>
                  <a:gd name="connsiteX4" fmla="*/ 80770 w 80233"/>
                  <a:gd name="connsiteY4" fmla="*/ 40356 h 802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0233" h="80233">
                    <a:moveTo>
                      <a:pt x="80770" y="40356"/>
                    </a:moveTo>
                    <a:cubicBezTo>
                      <a:pt x="80770" y="62511"/>
                      <a:pt x="62809" y="80472"/>
                      <a:pt x="40653" y="80472"/>
                    </a:cubicBezTo>
                    <a:cubicBezTo>
                      <a:pt x="18497" y="80472"/>
                      <a:pt x="536" y="62511"/>
                      <a:pt x="536" y="40356"/>
                    </a:cubicBezTo>
                    <a:cubicBezTo>
                      <a:pt x="536" y="18200"/>
                      <a:pt x="18497" y="239"/>
                      <a:pt x="40653" y="239"/>
                    </a:cubicBezTo>
                    <a:cubicBezTo>
                      <a:pt x="62809" y="239"/>
                      <a:pt x="80770" y="18200"/>
                      <a:pt x="80770" y="40356"/>
                    </a:cubicBezTo>
                    <a:close/>
                  </a:path>
                </a:pathLst>
              </a:custGeom>
              <a:solidFill>
                <a:srgbClr val="FFFFFF"/>
              </a:solidFill>
              <a:ln w="17822" cap="flat">
                <a:solidFill>
                  <a:srgbClr val="4682B4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 sz="2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79D46C56-040F-4ED0-BF17-C583A99CA275}"/>
                  </a:ext>
                </a:extLst>
              </p:cNvPr>
              <p:cNvSpPr txBox="1"/>
              <p:nvPr/>
            </p:nvSpPr>
            <p:spPr>
              <a:xfrm>
                <a:off x="5045805" y="2223799"/>
                <a:ext cx="1122423" cy="297517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pPr algn="l"/>
                <a:r>
                  <a:rPr lang="en-US" sz="2000" spc="0" baseline="20000">
                    <a:ln/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ourier New"/>
                    <a:rtl val="0"/>
                  </a:rPr>
                  <a:t>Nicbe_Roq1</a:t>
                </a:r>
              </a:p>
            </p:txBody>
          </p:sp>
        </p:grpSp>
        <p:grpSp>
          <p:nvGrpSpPr>
            <p:cNvPr id="134" name="Graphic 95">
              <a:extLst>
                <a:ext uri="{FF2B5EF4-FFF2-40B4-BE49-F238E27FC236}">
                  <a16:creationId xmlns:a16="http://schemas.microsoft.com/office/drawing/2014/main" id="{D962997D-5C5C-5D72-D68C-D96CBD23486F}"/>
                </a:ext>
              </a:extLst>
            </p:cNvPr>
            <p:cNvGrpSpPr/>
            <p:nvPr/>
          </p:nvGrpSpPr>
          <p:grpSpPr>
            <a:xfrm>
              <a:off x="5775298" y="552265"/>
              <a:ext cx="1095932" cy="297517"/>
              <a:chOff x="5775298" y="552265"/>
              <a:chExt cx="1095932" cy="297517"/>
            </a:xfrm>
          </p:grpSpPr>
          <p:sp>
            <p:nvSpPr>
              <p:cNvPr id="135" name="Freeform: Shape 134">
                <a:extLst>
                  <a:ext uri="{FF2B5EF4-FFF2-40B4-BE49-F238E27FC236}">
                    <a16:creationId xmlns:a16="http://schemas.microsoft.com/office/drawing/2014/main" id="{36BE78DF-C18F-8B0E-4737-CF50BEF58CE0}"/>
                  </a:ext>
                </a:extLst>
              </p:cNvPr>
              <p:cNvSpPr/>
              <p:nvPr/>
            </p:nvSpPr>
            <p:spPr>
              <a:xfrm>
                <a:off x="5775298" y="640884"/>
                <a:ext cx="80233" cy="80233"/>
              </a:xfrm>
              <a:custGeom>
                <a:avLst/>
                <a:gdLst>
                  <a:gd name="connsiteX0" fmla="*/ 80854 w 80233"/>
                  <a:gd name="connsiteY0" fmla="*/ 40168 h 80233"/>
                  <a:gd name="connsiteX1" fmla="*/ 40737 w 80233"/>
                  <a:gd name="connsiteY1" fmla="*/ 80285 h 80233"/>
                  <a:gd name="connsiteX2" fmla="*/ 620 w 80233"/>
                  <a:gd name="connsiteY2" fmla="*/ 40168 h 80233"/>
                  <a:gd name="connsiteX3" fmla="*/ 40737 w 80233"/>
                  <a:gd name="connsiteY3" fmla="*/ 51 h 80233"/>
                  <a:gd name="connsiteX4" fmla="*/ 80854 w 80233"/>
                  <a:gd name="connsiteY4" fmla="*/ 40168 h 802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0233" h="80233">
                    <a:moveTo>
                      <a:pt x="80854" y="40168"/>
                    </a:moveTo>
                    <a:cubicBezTo>
                      <a:pt x="80854" y="62324"/>
                      <a:pt x="62893" y="80285"/>
                      <a:pt x="40737" y="80285"/>
                    </a:cubicBezTo>
                    <a:cubicBezTo>
                      <a:pt x="18581" y="80285"/>
                      <a:pt x="620" y="62324"/>
                      <a:pt x="620" y="40168"/>
                    </a:cubicBezTo>
                    <a:cubicBezTo>
                      <a:pt x="620" y="18012"/>
                      <a:pt x="18581" y="51"/>
                      <a:pt x="40737" y="51"/>
                    </a:cubicBezTo>
                    <a:cubicBezTo>
                      <a:pt x="62893" y="51"/>
                      <a:pt x="80854" y="18012"/>
                      <a:pt x="80854" y="40168"/>
                    </a:cubicBezTo>
                    <a:close/>
                  </a:path>
                </a:pathLst>
              </a:custGeom>
              <a:solidFill>
                <a:srgbClr val="FFFFFF"/>
              </a:solidFill>
              <a:ln w="17822" cap="flat">
                <a:solidFill>
                  <a:srgbClr val="4682B4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 sz="2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D86D62D6-669F-6832-DC25-F428A8A08A56}"/>
                  </a:ext>
                </a:extLst>
              </p:cNvPr>
              <p:cNvSpPr txBox="1"/>
              <p:nvPr/>
            </p:nvSpPr>
            <p:spPr>
              <a:xfrm>
                <a:off x="5795294" y="552265"/>
                <a:ext cx="1075936" cy="297517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pPr algn="l"/>
                <a:r>
                  <a:rPr lang="en-US" sz="2000" spc="0" baseline="20000" dirty="0">
                    <a:ln/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Courier New"/>
                    <a:rtl val="0"/>
                  </a:rPr>
                  <a:t>Sollc_Sw5b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746435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76A956B-DF4F-3657-E3A5-591DDDF00D2D}"/>
              </a:ext>
            </a:extLst>
          </p:cNvPr>
          <p:cNvSpPr txBox="1"/>
          <p:nvPr/>
        </p:nvSpPr>
        <p:spPr>
          <a:xfrm>
            <a:off x="733770" y="5745239"/>
            <a:ext cx="776251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B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sequence alignment of Arahy.1PK53M.1 and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um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tatissimum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6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erisks show the identical amino acids, Colon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the conserved residues, 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le dots indicate the semi-conserved amino acids.  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073B9DD-02F4-A8A7-607E-CC26BDDF63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4406" y="268348"/>
            <a:ext cx="6486369" cy="5457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48059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F63B3020-53AC-C468-C7D6-7FC61EBB8F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499" y="540322"/>
            <a:ext cx="8001001" cy="486468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68D130B-37C1-C3DD-B5B0-1C9F048DDE85}"/>
              </a:ext>
            </a:extLst>
          </p:cNvPr>
          <p:cNvSpPr txBox="1"/>
          <p:nvPr/>
        </p:nvSpPr>
        <p:spPr>
          <a:xfrm>
            <a:off x="527669" y="5725886"/>
            <a:ext cx="82273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C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main search shows 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hy.1pK53M.1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ains TIR, NB-ARC, and LRR domains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4558812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68D130B-37C1-C3DD-B5B0-1C9F048DDE85}"/>
              </a:ext>
            </a:extLst>
          </p:cNvPr>
          <p:cNvSpPr txBox="1"/>
          <p:nvPr/>
        </p:nvSpPr>
        <p:spPr>
          <a:xfrm>
            <a:off x="527669" y="5725886"/>
            <a:ext cx="79458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D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main search shows 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w5b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ains RX-CC-like, NB-ARC, and LRR domains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CFF4DC79-A14E-A3AA-8F49-ACD344D5E7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074" y="610247"/>
            <a:ext cx="8179825" cy="49237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8399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D8A3826-6280-5760-5C86-3E668DA1D68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695" r="2994"/>
          <a:stretch/>
        </p:blipFill>
        <p:spPr>
          <a:xfrm>
            <a:off x="1475802" y="367748"/>
            <a:ext cx="6192395" cy="547124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B2CCE82-5EB0-31DE-754D-EEFEB6EA77A7}"/>
              </a:ext>
            </a:extLst>
          </p:cNvPr>
          <p:cNvSpPr txBox="1"/>
          <p:nvPr/>
        </p:nvSpPr>
        <p:spPr>
          <a:xfrm>
            <a:off x="733770" y="5745239"/>
            <a:ext cx="744158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sequence alignment of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hy.FX71XI.1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rdeum vulgare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LO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erisks show the identical amino acids, Colon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the conserved residues, 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le dots indicate the semi-conserved amino acids.   </a:t>
            </a:r>
          </a:p>
        </p:txBody>
      </p:sp>
    </p:spTree>
    <p:extLst>
      <p:ext uri="{BB962C8B-B14F-4D97-AF65-F5344CB8AC3E}">
        <p14:creationId xmlns:p14="http://schemas.microsoft.com/office/powerpoint/2010/main" val="181276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6BF7DAC6E33284EA2D5219CD3E2E522" ma:contentTypeVersion="5" ma:contentTypeDescription="Create a new document." ma:contentTypeScope="" ma:versionID="7831cc65408ed51b1531dedbd04dabf8">
  <xsd:schema xmlns:xsd="http://www.w3.org/2001/XMLSchema" xmlns:xs="http://www.w3.org/2001/XMLSchema" xmlns:p="http://schemas.microsoft.com/office/2006/metadata/properties" xmlns:ns3="7ea98dad-9eae-4a00-8103-441b9380c2c9" targetNamespace="http://schemas.microsoft.com/office/2006/metadata/properties" ma:root="true" ma:fieldsID="5944eea12b4ef37ffb91b64c78cbb6f8" ns3:_="">
    <xsd:import namespace="7ea98dad-9eae-4a00-8103-441b9380c2c9"/>
    <xsd:element name="properties">
      <xsd:complexType>
        <xsd:sequence>
          <xsd:element name="documentManagement">
            <xsd:complexType>
              <xsd:all>
                <xsd:element ref="ns3:MediaServiceDateTaken" minOccurs="0"/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ea98dad-9eae-4a00-8103-441b9380c2c9" elementFormDefault="qualified">
    <xsd:import namespace="http://schemas.microsoft.com/office/2006/documentManagement/types"/>
    <xsd:import namespace="http://schemas.microsoft.com/office/infopath/2007/PartnerControls"/>
    <xsd:element name="MediaServiceDateTaken" ma:index="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Metadata" ma:index="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630A4AF6-3514-4D0E-A9A5-BDA697610D0C}">
  <ds:schemaRefs>
    <ds:schemaRef ds:uri="http://schemas.microsoft.com/office/infopath/2007/PartnerControls"/>
    <ds:schemaRef ds:uri="http://www.w3.org/XML/1998/namespace"/>
    <ds:schemaRef ds:uri="7ea98dad-9eae-4a00-8103-441b9380c2c9"/>
    <ds:schemaRef ds:uri="http://schemas.openxmlformats.org/package/2006/metadata/core-properties"/>
    <ds:schemaRef ds:uri="http://schemas.microsoft.com/office/2006/documentManagement/types"/>
    <ds:schemaRef ds:uri="http://purl.org/dc/terms/"/>
    <ds:schemaRef ds:uri="http://schemas.microsoft.com/office/2006/metadata/properties"/>
    <ds:schemaRef ds:uri="http://purl.org/dc/dcmitype/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1767A1D7-8F23-4D48-B267-095A9D35966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636A98D-BFA7-48C3-8510-3E332E95176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ea98dad-9eae-4a00-8103-441b9380c2c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154</TotalTime>
  <Words>664</Words>
  <Application>Microsoft Office PowerPoint</Application>
  <PresentationFormat>Letter Paper (8.5x11 in)</PresentationFormat>
  <Paragraphs>84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Times</vt:lpstr>
      <vt:lpstr>Times New Roman</vt:lpstr>
      <vt:lpstr>Office 2013 - 2022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cz</dc:creator>
  <cp:lastModifiedBy>Guo, Baozhu</cp:lastModifiedBy>
  <cp:revision>88</cp:revision>
  <dcterms:created xsi:type="dcterms:W3CDTF">2019-11-21T14:11:54Z</dcterms:created>
  <dcterms:modified xsi:type="dcterms:W3CDTF">2025-02-06T13:57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6BF7DAC6E33284EA2D5219CD3E2E522</vt:lpwstr>
  </property>
</Properties>
</file>